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647" autoAdjust="0"/>
    <p:restoredTop sz="94882" autoAdjust="0"/>
  </p:normalViewPr>
  <p:slideViewPr>
    <p:cSldViewPr snapToGrid="0" snapToObjects="1">
      <p:cViewPr>
        <p:scale>
          <a:sx n="90" d="100"/>
          <a:sy n="90" d="100"/>
        </p:scale>
        <p:origin x="-496" y="-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1195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3003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9837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7449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2226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403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0310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5161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5225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4565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3481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74FB3-F147-F94C-AE65-214C7D04D30A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8B343-5707-4540-B217-0A5698F3C2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6758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テキスト ボックス 212"/>
          <p:cNvSpPr txBox="1"/>
          <p:nvPr/>
        </p:nvSpPr>
        <p:spPr>
          <a:xfrm>
            <a:off x="58061" y="27553"/>
            <a:ext cx="37191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/>
                <a:cs typeface="Arial"/>
              </a:rPr>
              <a:t>Supplemental Figure </a:t>
            </a:r>
            <a:r>
              <a:rPr lang="en-US" altLang="ja-JP" sz="1600" b="1" dirty="0" smtClean="0">
                <a:latin typeface="Arial"/>
                <a:cs typeface="Arial"/>
              </a:rPr>
              <a:t>3</a:t>
            </a:r>
            <a:r>
              <a:rPr lang="ja-JP" altLang="ja-JP" sz="1600" dirty="0" smtClean="0">
                <a:latin typeface="Arial"/>
                <a:cs typeface="Arial"/>
              </a:rPr>
              <a:t> </a:t>
            </a:r>
            <a:r>
              <a:rPr lang="en-US" altLang="ja-JP" sz="1600" b="1" dirty="0">
                <a:latin typeface="Arial"/>
                <a:cs typeface="Arial"/>
              </a:rPr>
              <a:t>, </a:t>
            </a:r>
            <a:r>
              <a:rPr lang="en-US" altLang="ja-JP" sz="1600" b="1" dirty="0" err="1">
                <a:latin typeface="Arial"/>
                <a:cs typeface="Arial"/>
              </a:rPr>
              <a:t>Osumi</a:t>
            </a:r>
            <a:r>
              <a:rPr lang="en-US" altLang="ja-JP" sz="1600" b="1" dirty="0">
                <a:latin typeface="Arial"/>
                <a:cs typeface="Arial"/>
              </a:rPr>
              <a:t> </a:t>
            </a:r>
            <a:r>
              <a:rPr lang="en-US" altLang="ja-JP" sz="1600" b="1" i="1" dirty="0">
                <a:latin typeface="Arial"/>
                <a:cs typeface="Arial"/>
              </a:rPr>
              <a:t>et al.</a:t>
            </a:r>
            <a:endParaRPr kumimoji="1" lang="ja-JP" altLang="en-US" sz="1600" b="1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28957" y="35743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</a:rPr>
              <a:t>A</a:t>
            </a:r>
            <a:endParaRPr kumimoji="1" lang="ja-JP" altLang="en-US" dirty="0">
              <a:solidFill>
                <a:srgbClr val="000000"/>
              </a:solidFill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811025" y="37503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000000"/>
                </a:solidFill>
              </a:rPr>
              <a:t>B</a:t>
            </a:r>
            <a:endParaRPr kumimoji="1" lang="ja-JP" altLang="en-US" dirty="0">
              <a:solidFill>
                <a:srgbClr val="000000"/>
              </a:solidFill>
            </a:endParaRPr>
          </a:p>
        </p:txBody>
      </p:sp>
      <p:sp>
        <p:nvSpPr>
          <p:cNvPr id="217" name="正方形/長方形 216"/>
          <p:cNvSpPr/>
          <p:nvPr/>
        </p:nvSpPr>
        <p:spPr>
          <a:xfrm>
            <a:off x="-32839" y="5372835"/>
            <a:ext cx="1712987" cy="4739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mr-IN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cs typeface="Arial"/>
              </a:rPr>
              <a:t>　　　　　　　　　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                       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A19-9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&gt; average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A19-9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 average </a:t>
            </a: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870678" y="31164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000000"/>
                </a:solidFill>
              </a:rPr>
              <a:t>C</a:t>
            </a:r>
            <a:endParaRPr kumimoji="1" lang="ja-JP" altLang="en-US" dirty="0">
              <a:solidFill>
                <a:srgbClr val="000000"/>
              </a:solidFill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4837274" y="3186548"/>
            <a:ext cx="33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000000"/>
                </a:solidFill>
              </a:rPr>
              <a:t>D</a:t>
            </a:r>
            <a:endParaRPr kumimoji="1" lang="ja-JP" altLang="en-US" dirty="0">
              <a:solidFill>
                <a:srgbClr val="000000"/>
              </a:solidFill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607226" y="523855"/>
            <a:ext cx="2287806" cy="954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EA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at 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8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weeks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&gt;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 average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EA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at 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8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weeks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 average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Hazard ratio 0.37, 95% CI 0.14–0.96,</a:t>
            </a: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 = 0.03</a:t>
            </a:r>
          </a:p>
          <a:p>
            <a:pPr>
              <a:lnSpc>
                <a:spcPct val="110000"/>
              </a:lnSpc>
            </a:pPr>
            <a:endParaRPr kumimoji="1" lang="ja-JP" altLang="en-US" sz="75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428859" y="2547739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solidFill>
                  <a:srgbClr val="000000"/>
                </a:solidFill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34006" y="2693445"/>
            <a:ext cx="1932081" cy="3447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EA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</a:t>
            </a:r>
            <a:r>
              <a:rPr lang="en-US" altLang="ja-JP" sz="600" dirty="0"/>
              <a:t>&gt;  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average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EA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 average </a:t>
            </a:r>
          </a:p>
        </p:txBody>
      </p:sp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7524662"/>
              </p:ext>
            </p:extLst>
          </p:nvPr>
        </p:nvGraphicFramePr>
        <p:xfrm>
          <a:off x="1484679" y="2775954"/>
          <a:ext cx="2170024" cy="238759"/>
        </p:xfrm>
        <a:graphic>
          <a:graphicData uri="http://schemas.openxmlformats.org/drawingml/2006/table">
            <a:tbl>
              <a:tblPr/>
              <a:tblGrid>
                <a:gridCol w="27125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7125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7125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7125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7125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27125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27125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71253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214" name="テキスト ボックス 213"/>
          <p:cNvSpPr txBox="1"/>
          <p:nvPr/>
        </p:nvSpPr>
        <p:spPr>
          <a:xfrm>
            <a:off x="2417396" y="3274575"/>
            <a:ext cx="2408032" cy="8187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A19-9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at 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8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weeks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&gt;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 average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A19-9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at 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8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weeks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 average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Hazard ratio </a:t>
            </a:r>
            <a:r>
              <a:rPr lang="en-US" altLang="ja-JP" sz="750" dirty="0" smtClean="0">
                <a:solidFill>
                  <a:srgbClr val="000000"/>
                </a:solidFill>
                <a:latin typeface="Arial"/>
                <a:cs typeface="Arial"/>
              </a:rPr>
              <a:t>0.31, 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95% CI 0.10</a:t>
            </a:r>
            <a:r>
              <a:rPr lang="en-US" altLang="ja-JP" sz="750" dirty="0" smtClean="0">
                <a:solidFill>
                  <a:srgbClr val="000000"/>
                </a:solidFill>
                <a:latin typeface="Arial"/>
                <a:cs typeface="Arial"/>
              </a:rPr>
              <a:t>–</a:t>
            </a:r>
            <a:r>
              <a:rPr lang="ja-JP" altLang="ja-JP" sz="75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r>
              <a:rPr lang="en-US" altLang="ja-JP" sz="750" dirty="0" smtClean="0">
                <a:solidFill>
                  <a:srgbClr val="000000"/>
                </a:solidFill>
                <a:latin typeface="Arial"/>
                <a:cs typeface="Arial"/>
              </a:rPr>
              <a:t>.99,</a:t>
            </a:r>
            <a:endParaRPr lang="en-US" altLang="ja-JP" sz="750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 = 0.04</a:t>
            </a:r>
          </a:p>
        </p:txBody>
      </p:sp>
      <p:sp>
        <p:nvSpPr>
          <p:cNvPr id="215" name="テキスト ボックス 214"/>
          <p:cNvSpPr txBox="1"/>
          <p:nvPr/>
        </p:nvSpPr>
        <p:spPr>
          <a:xfrm>
            <a:off x="341669" y="5370612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solidFill>
                  <a:srgbClr val="000000"/>
                </a:solidFill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graphicFrame>
        <p:nvGraphicFramePr>
          <p:cNvPr id="219" name="表 2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7530631"/>
              </p:ext>
            </p:extLst>
          </p:nvPr>
        </p:nvGraphicFramePr>
        <p:xfrm>
          <a:off x="1485886" y="5573724"/>
          <a:ext cx="2270020" cy="238759"/>
        </p:xfrm>
        <a:graphic>
          <a:graphicData uri="http://schemas.openxmlformats.org/drawingml/2006/table">
            <a:tbl>
              <a:tblPr/>
              <a:tblGrid>
                <a:gridCol w="28849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8849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8849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8849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8849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28849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28849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50569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352" name="テキスト ボックス 351"/>
          <p:cNvSpPr txBox="1"/>
          <p:nvPr/>
        </p:nvSpPr>
        <p:spPr>
          <a:xfrm>
            <a:off x="4274207" y="2534418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solidFill>
                  <a:srgbClr val="000000"/>
                </a:solidFill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53" name="正方形/長方形 352"/>
          <p:cNvSpPr/>
          <p:nvPr/>
        </p:nvSpPr>
        <p:spPr>
          <a:xfrm>
            <a:off x="3840629" y="2683135"/>
            <a:ext cx="1661703" cy="3447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EA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&gt; average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EA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 average </a:t>
            </a:r>
          </a:p>
        </p:txBody>
      </p:sp>
      <p:graphicFrame>
        <p:nvGraphicFramePr>
          <p:cNvPr id="354" name="表 35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4910966"/>
              </p:ext>
            </p:extLst>
          </p:nvPr>
        </p:nvGraphicFramePr>
        <p:xfrm>
          <a:off x="5258099" y="2757977"/>
          <a:ext cx="2357264" cy="238759"/>
        </p:xfrm>
        <a:graphic>
          <a:graphicData uri="http://schemas.openxmlformats.org/drawingml/2006/table">
            <a:tbl>
              <a:tblPr/>
              <a:tblGrid>
                <a:gridCol w="29475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9475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9475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94759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94759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294759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294759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93951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355" name="正方形/長方形 354"/>
          <p:cNvSpPr/>
          <p:nvPr/>
        </p:nvSpPr>
        <p:spPr>
          <a:xfrm>
            <a:off x="3755904" y="5372514"/>
            <a:ext cx="1761486" cy="4739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mr-IN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cs typeface="Arial"/>
              </a:rPr>
              <a:t>　　　　　　　　　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                     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A19-9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&gt; average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A19-9</a:t>
            </a:r>
            <a:r>
              <a:rPr lang="ja-JP" altLang="en-US" sz="6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 average </a:t>
            </a:r>
          </a:p>
        </p:txBody>
      </p:sp>
      <p:sp>
        <p:nvSpPr>
          <p:cNvPr id="356" name="テキスト ボックス 355"/>
          <p:cNvSpPr txBox="1"/>
          <p:nvPr/>
        </p:nvSpPr>
        <p:spPr>
          <a:xfrm>
            <a:off x="4258810" y="5344318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solidFill>
                  <a:srgbClr val="000000"/>
                </a:solidFill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graphicFrame>
        <p:nvGraphicFramePr>
          <p:cNvPr id="357" name="表 35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6652222"/>
              </p:ext>
            </p:extLst>
          </p:nvPr>
        </p:nvGraphicFramePr>
        <p:xfrm>
          <a:off x="5289996" y="5573772"/>
          <a:ext cx="2379216" cy="238759"/>
        </p:xfrm>
        <a:graphic>
          <a:graphicData uri="http://schemas.openxmlformats.org/drawingml/2006/table">
            <a:tbl>
              <a:tblPr/>
              <a:tblGrid>
                <a:gridCol w="29740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9740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9740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9740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97402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297402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297402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97402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358" name="テキスト ボックス 357"/>
          <p:cNvSpPr txBox="1"/>
          <p:nvPr/>
        </p:nvSpPr>
        <p:spPr>
          <a:xfrm>
            <a:off x="6966743" y="342713"/>
            <a:ext cx="2287806" cy="954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EA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at 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8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weeks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&gt;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 average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EA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at 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8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weeks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 average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Hazard ratio </a:t>
            </a:r>
            <a:r>
              <a:rPr lang="en-US" altLang="ja-JP" sz="750" dirty="0" smtClean="0">
                <a:solidFill>
                  <a:srgbClr val="000000"/>
                </a:solidFill>
                <a:latin typeface="Arial"/>
                <a:cs typeface="Arial"/>
              </a:rPr>
              <a:t>0.36, 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95% CI </a:t>
            </a:r>
            <a:r>
              <a:rPr lang="en-US" altLang="ja-JP" sz="750" dirty="0" smtClean="0">
                <a:solidFill>
                  <a:srgbClr val="000000"/>
                </a:solidFill>
                <a:latin typeface="Arial"/>
                <a:cs typeface="Arial"/>
              </a:rPr>
              <a:t>0.1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r>
              <a:rPr lang="en-US" altLang="ja-JP" sz="750" dirty="0" smtClean="0">
                <a:solidFill>
                  <a:srgbClr val="000000"/>
                </a:solidFill>
                <a:latin typeface="Arial"/>
                <a:cs typeface="Arial"/>
              </a:rPr>
              <a:t>–1.15,</a:t>
            </a:r>
            <a:endParaRPr lang="en-US" altLang="ja-JP" sz="750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solidFill>
                  <a:srgbClr val="000000"/>
                </a:solidFill>
                <a:latin typeface="Arial"/>
                <a:cs typeface="Arial"/>
              </a:rPr>
              <a:t>P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= 0.07</a:t>
            </a:r>
          </a:p>
          <a:p>
            <a:pPr>
              <a:lnSpc>
                <a:spcPct val="110000"/>
              </a:lnSpc>
            </a:pPr>
            <a:endParaRPr kumimoji="1" lang="ja-JP" altLang="en-US" sz="75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59" name="テキスト ボックス 358"/>
          <p:cNvSpPr txBox="1"/>
          <p:nvPr/>
        </p:nvSpPr>
        <p:spPr>
          <a:xfrm>
            <a:off x="6837705" y="3236521"/>
            <a:ext cx="2408032" cy="954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A19-9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at 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8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weeks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&gt; 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average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/before ratio of </a:t>
            </a:r>
            <a:r>
              <a:rPr lang="en-US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CA19-9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level at 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8</a:t>
            </a:r>
            <a:r>
              <a:rPr lang="ja-JP" altLang="en-US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weeks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 average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  </a:t>
            </a:r>
            <a:r>
              <a:rPr lang="en-US" altLang="ja-JP" sz="750" dirty="0" smtClean="0">
                <a:solidFill>
                  <a:srgbClr val="000000"/>
                </a:solidFill>
                <a:latin typeface="Arial"/>
                <a:cs typeface="Arial"/>
              </a:rPr>
              <a:t>Hazard 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ratio </a:t>
            </a:r>
            <a:r>
              <a:rPr lang="en-US" altLang="ja-JP" sz="750" dirty="0" smtClean="0">
                <a:solidFill>
                  <a:srgbClr val="000000"/>
                </a:solidFill>
                <a:latin typeface="Arial"/>
                <a:cs typeface="Arial"/>
              </a:rPr>
              <a:t>0.07, </a:t>
            </a:r>
            <a:r>
              <a:rPr lang="en-US" altLang="ja-JP" sz="750" dirty="0">
                <a:solidFill>
                  <a:srgbClr val="000000"/>
                </a:solidFill>
                <a:latin typeface="Arial"/>
                <a:cs typeface="Arial"/>
              </a:rPr>
              <a:t>95% CI 0.01–0.49,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4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lang="en-US" altLang="ja-JP" sz="12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Arial"/>
                <a:cs typeface="Arial"/>
              </a:rPr>
              <a:t>= 0.0005</a:t>
            </a:r>
          </a:p>
          <a:p>
            <a:pPr>
              <a:lnSpc>
                <a:spcPct val="110000"/>
              </a:lnSpc>
            </a:pPr>
            <a:endParaRPr kumimoji="1" lang="ja-JP" altLang="en-US" sz="75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grpSp>
        <p:nvGrpSpPr>
          <p:cNvPr id="449" name="図形グループ 448"/>
          <p:cNvGrpSpPr/>
          <p:nvPr/>
        </p:nvGrpSpPr>
        <p:grpSpPr>
          <a:xfrm>
            <a:off x="1182910" y="3239287"/>
            <a:ext cx="2585624" cy="2311905"/>
            <a:chOff x="1182909" y="3827374"/>
            <a:chExt cx="2668543" cy="2358814"/>
          </a:xfrm>
        </p:grpSpPr>
        <p:sp>
          <p:nvSpPr>
            <p:cNvPr id="11" name="Line 5">
              <a:extLst>
                <a:ext uri="{FF2B5EF4-FFF2-40B4-BE49-F238E27FC236}">
                  <a16:creationId xmlns:a16="http://schemas.microsoft.com/office/drawing/2014/main" xmlns="" id="{5D3E5F24-8A3F-411B-ACD6-E456ABF6AA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29212" y="5812563"/>
              <a:ext cx="203981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2" name="Line 6">
              <a:extLst>
                <a:ext uri="{FF2B5EF4-FFF2-40B4-BE49-F238E27FC236}">
                  <a16:creationId xmlns:a16="http://schemas.microsoft.com/office/drawing/2014/main" xmlns="" id="{A9C808F2-0481-41AE-9D5C-1280790494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29212" y="5812563"/>
              <a:ext cx="0" cy="3804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3" name="Line 7">
              <a:extLst>
                <a:ext uri="{FF2B5EF4-FFF2-40B4-BE49-F238E27FC236}">
                  <a16:creationId xmlns:a16="http://schemas.microsoft.com/office/drawing/2014/main" xmlns="" id="{5FFEFE1B-59B0-4245-A717-637D7F939A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9917" y="5812563"/>
              <a:ext cx="0" cy="3804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4" name="Line 8">
              <a:extLst>
                <a:ext uri="{FF2B5EF4-FFF2-40B4-BE49-F238E27FC236}">
                  <a16:creationId xmlns:a16="http://schemas.microsoft.com/office/drawing/2014/main" xmlns="" id="{46ECC462-C46B-4EDD-978F-035F9028A1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4525" y="5812563"/>
              <a:ext cx="0" cy="3804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5" name="Line 9">
              <a:extLst>
                <a:ext uri="{FF2B5EF4-FFF2-40B4-BE49-F238E27FC236}">
                  <a16:creationId xmlns:a16="http://schemas.microsoft.com/office/drawing/2014/main" xmlns="" id="{7BB74BD9-35BD-4736-8401-80D19E56D0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05231" y="5812563"/>
              <a:ext cx="0" cy="3804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6" name="Line 10">
              <a:extLst>
                <a:ext uri="{FF2B5EF4-FFF2-40B4-BE49-F238E27FC236}">
                  <a16:creationId xmlns:a16="http://schemas.microsoft.com/office/drawing/2014/main" xmlns="" id="{748DD1E9-772D-4696-9867-7EF20BFF94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5937" y="5812563"/>
              <a:ext cx="0" cy="3804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7" name="Line 11">
              <a:extLst>
                <a:ext uri="{FF2B5EF4-FFF2-40B4-BE49-F238E27FC236}">
                  <a16:creationId xmlns:a16="http://schemas.microsoft.com/office/drawing/2014/main" xmlns="" id="{0031081F-2544-4243-8A31-6336B5776B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6642" y="5812563"/>
              <a:ext cx="0" cy="3804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8" name="Line 12">
              <a:extLst>
                <a:ext uri="{FF2B5EF4-FFF2-40B4-BE49-F238E27FC236}">
                  <a16:creationId xmlns:a16="http://schemas.microsoft.com/office/drawing/2014/main" xmlns="" id="{8C622BE4-4237-4803-A18A-AE92F2343D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8324" y="5812563"/>
              <a:ext cx="0" cy="3804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9" name="Line 13">
              <a:extLst>
                <a:ext uri="{FF2B5EF4-FFF2-40B4-BE49-F238E27FC236}">
                  <a16:creationId xmlns:a16="http://schemas.microsoft.com/office/drawing/2014/main" xmlns="" id="{D80201FF-D05E-43DD-97B0-A00C5ED279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69029" y="5812563"/>
              <a:ext cx="0" cy="3804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0" name="Rectangle 14">
              <a:extLst>
                <a:ext uri="{FF2B5EF4-FFF2-40B4-BE49-F238E27FC236}">
                  <a16:creationId xmlns:a16="http://schemas.microsoft.com/office/drawing/2014/main" xmlns="" id="{FDB66946-0308-4C76-97E1-A49A9F082D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6044" y="5899384"/>
              <a:ext cx="64384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1" name="Rectangle 15">
              <a:extLst>
                <a:ext uri="{FF2B5EF4-FFF2-40B4-BE49-F238E27FC236}">
                  <a16:creationId xmlns:a16="http://schemas.microsoft.com/office/drawing/2014/main" xmlns="" id="{522BB32E-E5A2-4E8D-BF85-5029E599CB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6750" y="5899384"/>
              <a:ext cx="64384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2" name="Rectangle 16">
              <a:extLst>
                <a:ext uri="{FF2B5EF4-FFF2-40B4-BE49-F238E27FC236}">
                  <a16:creationId xmlns:a16="http://schemas.microsoft.com/office/drawing/2014/main" xmlns="" id="{229D1622-6532-4E68-8ABA-755235A8CD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1358" y="5899384"/>
              <a:ext cx="64384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3" name="Rectangle 17">
              <a:extLst>
                <a:ext uri="{FF2B5EF4-FFF2-40B4-BE49-F238E27FC236}">
                  <a16:creationId xmlns:a16="http://schemas.microsoft.com/office/drawing/2014/main" xmlns="" id="{62383137-22A8-4EF0-B1E6-DD77440BC5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2063" y="5899384"/>
              <a:ext cx="64384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" name="Rectangle 18">
              <a:extLst>
                <a:ext uri="{FF2B5EF4-FFF2-40B4-BE49-F238E27FC236}">
                  <a16:creationId xmlns:a16="http://schemas.microsoft.com/office/drawing/2014/main" xmlns="" id="{C5A55AF7-0000-4770-B393-6AC441011B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2769" y="5899384"/>
              <a:ext cx="64384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" name="Rectangle 19">
              <a:extLst>
                <a:ext uri="{FF2B5EF4-FFF2-40B4-BE49-F238E27FC236}">
                  <a16:creationId xmlns:a16="http://schemas.microsoft.com/office/drawing/2014/main" xmlns="" id="{D0BA468D-977A-44DB-B00D-20E9F34A2E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2989" y="5899384"/>
              <a:ext cx="128769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6" name="Rectangle 20">
              <a:extLst>
                <a:ext uri="{FF2B5EF4-FFF2-40B4-BE49-F238E27FC236}">
                  <a16:creationId xmlns:a16="http://schemas.microsoft.com/office/drawing/2014/main" xmlns="" id="{2D759CE2-4CA5-4459-BA15-48F4C6F5CF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4670" y="5899384"/>
              <a:ext cx="128769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" name="Rectangle 21">
              <a:extLst>
                <a:ext uri="{FF2B5EF4-FFF2-40B4-BE49-F238E27FC236}">
                  <a16:creationId xmlns:a16="http://schemas.microsoft.com/office/drawing/2014/main" xmlns="" id="{D286D6E2-D75D-4180-A1FE-AC642C1B51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5376" y="5899384"/>
              <a:ext cx="128769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8" name="Line 22">
              <a:extLst>
                <a:ext uri="{FF2B5EF4-FFF2-40B4-BE49-F238E27FC236}">
                  <a16:creationId xmlns:a16="http://schemas.microsoft.com/office/drawing/2014/main" xmlns="" id="{8337DE9D-DB0F-49F8-97D3-156DE468EF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29212" y="3902489"/>
              <a:ext cx="0" cy="18359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9" name="Line 23">
              <a:extLst>
                <a:ext uri="{FF2B5EF4-FFF2-40B4-BE49-F238E27FC236}">
                  <a16:creationId xmlns:a16="http://schemas.microsoft.com/office/drawing/2014/main" xmlns="" id="{2DA5388A-EB59-4818-B0B5-EC6E26E9B5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92142" y="5738423"/>
              <a:ext cx="370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0" name="Line 24">
              <a:extLst>
                <a:ext uri="{FF2B5EF4-FFF2-40B4-BE49-F238E27FC236}">
                  <a16:creationId xmlns:a16="http://schemas.microsoft.com/office/drawing/2014/main" xmlns="" id="{4A3B224C-44CA-42C1-99B1-D9F7E979CA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92142" y="5368700"/>
              <a:ext cx="370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1" name="Line 25">
              <a:extLst>
                <a:ext uri="{FF2B5EF4-FFF2-40B4-BE49-F238E27FC236}">
                  <a16:creationId xmlns:a16="http://schemas.microsoft.com/office/drawing/2014/main" xmlns="" id="{34FB0211-2133-4198-9C6F-3CE4BA18DB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92142" y="5002879"/>
              <a:ext cx="370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64" name="Line 26">
              <a:extLst>
                <a:ext uri="{FF2B5EF4-FFF2-40B4-BE49-F238E27FC236}">
                  <a16:creationId xmlns:a16="http://schemas.microsoft.com/office/drawing/2014/main" xmlns="" id="{5FDD311F-982D-4A46-9527-D0BEB6EEE1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92142" y="4637058"/>
              <a:ext cx="370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65" name="Line 27">
              <a:extLst>
                <a:ext uri="{FF2B5EF4-FFF2-40B4-BE49-F238E27FC236}">
                  <a16:creationId xmlns:a16="http://schemas.microsoft.com/office/drawing/2014/main" xmlns="" id="{A341F738-4427-4962-B877-9E794A7C48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92142" y="4267335"/>
              <a:ext cx="370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67" name="Line 28">
              <a:extLst>
                <a:ext uri="{FF2B5EF4-FFF2-40B4-BE49-F238E27FC236}">
                  <a16:creationId xmlns:a16="http://schemas.microsoft.com/office/drawing/2014/main" xmlns="" id="{34232034-74A8-47D1-B83F-910D91E7AA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92142" y="3902489"/>
              <a:ext cx="370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68" name="Rectangle 29">
              <a:extLst>
                <a:ext uri="{FF2B5EF4-FFF2-40B4-BE49-F238E27FC236}">
                  <a16:creationId xmlns:a16="http://schemas.microsoft.com/office/drawing/2014/main" xmlns="" id="{F9465974-471A-438C-A04C-D314D0530F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1174" y="5665259"/>
              <a:ext cx="64384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69" name="Rectangle 30">
              <a:extLst>
                <a:ext uri="{FF2B5EF4-FFF2-40B4-BE49-F238E27FC236}">
                  <a16:creationId xmlns:a16="http://schemas.microsoft.com/office/drawing/2014/main" xmlns="" id="{D5416058-4A05-499A-AD22-043ABB44FF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6789" y="5289683"/>
              <a:ext cx="128769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70" name="Rectangle 31">
              <a:extLst>
                <a:ext uri="{FF2B5EF4-FFF2-40B4-BE49-F238E27FC236}">
                  <a16:creationId xmlns:a16="http://schemas.microsoft.com/office/drawing/2014/main" xmlns="" id="{D334B3C6-6B10-4F69-8D7F-9060A58C46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6789" y="4923862"/>
              <a:ext cx="128769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71" name="Rectangle 32">
              <a:extLst>
                <a:ext uri="{FF2B5EF4-FFF2-40B4-BE49-F238E27FC236}">
                  <a16:creationId xmlns:a16="http://schemas.microsoft.com/office/drawing/2014/main" xmlns="" id="{BC78136B-4671-45CE-95E1-9E700648FF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6789" y="4554138"/>
              <a:ext cx="128769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72" name="Rectangle 33">
              <a:extLst>
                <a:ext uri="{FF2B5EF4-FFF2-40B4-BE49-F238E27FC236}">
                  <a16:creationId xmlns:a16="http://schemas.microsoft.com/office/drawing/2014/main" xmlns="" id="{96221C98-33A6-4BAA-B550-244062E3A7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6789" y="4188317"/>
              <a:ext cx="128769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73" name="Rectangle 34">
              <a:extLst>
                <a:ext uri="{FF2B5EF4-FFF2-40B4-BE49-F238E27FC236}">
                  <a16:creationId xmlns:a16="http://schemas.microsoft.com/office/drawing/2014/main" xmlns="" id="{E98722EB-356E-4404-A10B-CD98867D17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3866" y="3830301"/>
              <a:ext cx="192178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74" name="Freeform 35">
              <a:extLst>
                <a:ext uri="{FF2B5EF4-FFF2-40B4-BE49-F238E27FC236}">
                  <a16:creationId xmlns:a16="http://schemas.microsoft.com/office/drawing/2014/main" xmlns="" id="{9CD72A4C-4275-4D96-B06E-967C3FF4ECE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9212" y="3827374"/>
              <a:ext cx="2222240" cy="1985189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75" name="Rectangle 36">
              <a:extLst>
                <a:ext uri="{FF2B5EF4-FFF2-40B4-BE49-F238E27FC236}">
                  <a16:creationId xmlns:a16="http://schemas.microsoft.com/office/drawing/2014/main" xmlns="" id="{70878EEF-E427-4A67-A733-6D7779A01E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0130" y="6047664"/>
              <a:ext cx="795051" cy="1385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(months)</a:t>
              </a:r>
              <a:endParaRPr kumimoji="0" lang="ja-JP" altLang="ja-JP" b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76" name="Rectangle 37">
              <a:extLst>
                <a:ext uri="{FF2B5EF4-FFF2-40B4-BE49-F238E27FC236}">
                  <a16:creationId xmlns:a16="http://schemas.microsoft.com/office/drawing/2014/main" xmlns="" id="{8BD68AD4-01C7-4B4C-B7FB-09699CE8E86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68836" y="4743390"/>
              <a:ext cx="1782280" cy="154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1000" b="1" dirty="0">
                  <a:solidFill>
                    <a:srgbClr val="000000"/>
                  </a:solidFill>
                  <a:latin typeface="Arial"/>
                  <a:cs typeface="Arial"/>
                </a:rPr>
                <a:t>Progression-free survival (%)</a:t>
              </a:r>
              <a:endParaRPr kumimoji="0" lang="ja-JP" altLang="ja-JP" sz="1000" b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77" name="Freeform 38">
              <a:extLst>
                <a:ext uri="{FF2B5EF4-FFF2-40B4-BE49-F238E27FC236}">
                  <a16:creationId xmlns:a16="http://schemas.microsoft.com/office/drawing/2014/main" xmlns="" id="{FB7ECF0D-0939-4320-AC69-423F9F5F48B5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9212" y="3902489"/>
              <a:ext cx="680915" cy="1835934"/>
            </a:xfrm>
            <a:custGeom>
              <a:avLst/>
              <a:gdLst>
                <a:gd name="T0" fmla="*/ 0 w 164"/>
                <a:gd name="T1" fmla="*/ 0 h 442"/>
                <a:gd name="T2" fmla="*/ 52 w 164"/>
                <a:gd name="T3" fmla="*/ 0 h 442"/>
                <a:gd name="T4" fmla="*/ 52 w 164"/>
                <a:gd name="T5" fmla="*/ 110 h 442"/>
                <a:gd name="T6" fmla="*/ 74 w 164"/>
                <a:gd name="T7" fmla="*/ 110 h 442"/>
                <a:gd name="T8" fmla="*/ 74 w 164"/>
                <a:gd name="T9" fmla="*/ 221 h 442"/>
                <a:gd name="T10" fmla="*/ 76 w 164"/>
                <a:gd name="T11" fmla="*/ 221 h 442"/>
                <a:gd name="T12" fmla="*/ 76 w 164"/>
                <a:gd name="T13" fmla="*/ 331 h 442"/>
                <a:gd name="T14" fmla="*/ 164 w 164"/>
                <a:gd name="T15" fmla="*/ 331 h 442"/>
                <a:gd name="T16" fmla="*/ 164 w 164"/>
                <a:gd name="T17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64" h="442">
                  <a:moveTo>
                    <a:pt x="0" y="0"/>
                  </a:moveTo>
                  <a:lnTo>
                    <a:pt x="52" y="0"/>
                  </a:lnTo>
                  <a:lnTo>
                    <a:pt x="52" y="110"/>
                  </a:lnTo>
                  <a:lnTo>
                    <a:pt x="74" y="110"/>
                  </a:lnTo>
                  <a:lnTo>
                    <a:pt x="74" y="221"/>
                  </a:lnTo>
                  <a:lnTo>
                    <a:pt x="76" y="221"/>
                  </a:lnTo>
                  <a:lnTo>
                    <a:pt x="76" y="331"/>
                  </a:lnTo>
                  <a:lnTo>
                    <a:pt x="164" y="331"/>
                  </a:lnTo>
                  <a:lnTo>
                    <a:pt x="164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78" name="Freeform 39">
              <a:extLst>
                <a:ext uri="{FF2B5EF4-FFF2-40B4-BE49-F238E27FC236}">
                  <a16:creationId xmlns:a16="http://schemas.microsoft.com/office/drawing/2014/main" xmlns="" id="{BCDD43CF-7B6B-4395-87CF-923113A73CBC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9212" y="3902489"/>
              <a:ext cx="2139321" cy="1835934"/>
            </a:xfrm>
            <a:custGeom>
              <a:avLst/>
              <a:gdLst>
                <a:gd name="T0" fmla="*/ 0 w 515"/>
                <a:gd name="T1" fmla="*/ 0 h 442"/>
                <a:gd name="T2" fmla="*/ 32 w 515"/>
                <a:gd name="T3" fmla="*/ 0 h 442"/>
                <a:gd name="T4" fmla="*/ 32 w 515"/>
                <a:gd name="T5" fmla="*/ 20 h 442"/>
                <a:gd name="T6" fmla="*/ 58 w 515"/>
                <a:gd name="T7" fmla="*/ 20 h 442"/>
                <a:gd name="T8" fmla="*/ 58 w 515"/>
                <a:gd name="T9" fmla="*/ 40 h 442"/>
                <a:gd name="T10" fmla="*/ 66 w 515"/>
                <a:gd name="T11" fmla="*/ 40 h 442"/>
                <a:gd name="T12" fmla="*/ 66 w 515"/>
                <a:gd name="T13" fmla="*/ 60 h 442"/>
                <a:gd name="T14" fmla="*/ 72 w 515"/>
                <a:gd name="T15" fmla="*/ 60 h 442"/>
                <a:gd name="T16" fmla="*/ 72 w 515"/>
                <a:gd name="T17" fmla="*/ 80 h 442"/>
                <a:gd name="T18" fmla="*/ 81 w 515"/>
                <a:gd name="T19" fmla="*/ 80 h 442"/>
                <a:gd name="T20" fmla="*/ 81 w 515"/>
                <a:gd name="T21" fmla="*/ 100 h 442"/>
                <a:gd name="T22" fmla="*/ 104 w 515"/>
                <a:gd name="T23" fmla="*/ 100 h 442"/>
                <a:gd name="T24" fmla="*/ 104 w 515"/>
                <a:gd name="T25" fmla="*/ 120 h 442"/>
                <a:gd name="T26" fmla="*/ 107 w 515"/>
                <a:gd name="T27" fmla="*/ 120 h 442"/>
                <a:gd name="T28" fmla="*/ 107 w 515"/>
                <a:gd name="T29" fmla="*/ 141 h 442"/>
                <a:gd name="T30" fmla="*/ 123 w 515"/>
                <a:gd name="T31" fmla="*/ 141 h 442"/>
                <a:gd name="T32" fmla="*/ 123 w 515"/>
                <a:gd name="T33" fmla="*/ 161 h 442"/>
                <a:gd name="T34" fmla="*/ 129 w 515"/>
                <a:gd name="T35" fmla="*/ 161 h 442"/>
                <a:gd name="T36" fmla="*/ 129 w 515"/>
                <a:gd name="T37" fmla="*/ 181 h 442"/>
                <a:gd name="T38" fmla="*/ 155 w 515"/>
                <a:gd name="T39" fmla="*/ 181 h 442"/>
                <a:gd name="T40" fmla="*/ 155 w 515"/>
                <a:gd name="T41" fmla="*/ 201 h 442"/>
                <a:gd name="T42" fmla="*/ 156 w 515"/>
                <a:gd name="T43" fmla="*/ 201 h 442"/>
                <a:gd name="T44" fmla="*/ 156 w 515"/>
                <a:gd name="T45" fmla="*/ 221 h 442"/>
                <a:gd name="T46" fmla="*/ 164 w 515"/>
                <a:gd name="T47" fmla="*/ 221 h 442"/>
                <a:gd name="T48" fmla="*/ 164 w 515"/>
                <a:gd name="T49" fmla="*/ 243 h 442"/>
                <a:gd name="T50" fmla="*/ 181 w 515"/>
                <a:gd name="T51" fmla="*/ 243 h 442"/>
                <a:gd name="T52" fmla="*/ 181 w 515"/>
                <a:gd name="T53" fmla="*/ 265 h 442"/>
                <a:gd name="T54" fmla="*/ 198 w 515"/>
                <a:gd name="T55" fmla="*/ 265 h 442"/>
                <a:gd name="T56" fmla="*/ 198 w 515"/>
                <a:gd name="T57" fmla="*/ 287 h 442"/>
                <a:gd name="T58" fmla="*/ 205 w 515"/>
                <a:gd name="T59" fmla="*/ 287 h 442"/>
                <a:gd name="T60" fmla="*/ 205 w 515"/>
                <a:gd name="T61" fmla="*/ 309 h 442"/>
                <a:gd name="T62" fmla="*/ 207 w 515"/>
                <a:gd name="T63" fmla="*/ 309 h 442"/>
                <a:gd name="T64" fmla="*/ 207 w 515"/>
                <a:gd name="T65" fmla="*/ 331 h 442"/>
                <a:gd name="T66" fmla="*/ 215 w 515"/>
                <a:gd name="T67" fmla="*/ 331 h 442"/>
                <a:gd name="T68" fmla="*/ 215 w 515"/>
                <a:gd name="T69" fmla="*/ 353 h 442"/>
                <a:gd name="T70" fmla="*/ 281 w 515"/>
                <a:gd name="T71" fmla="*/ 353 h 442"/>
                <a:gd name="T72" fmla="*/ 281 w 515"/>
                <a:gd name="T73" fmla="*/ 376 h 442"/>
                <a:gd name="T74" fmla="*/ 295 w 515"/>
                <a:gd name="T75" fmla="*/ 376 h 442"/>
                <a:gd name="T76" fmla="*/ 295 w 515"/>
                <a:gd name="T77" fmla="*/ 398 h 442"/>
                <a:gd name="T78" fmla="*/ 401 w 515"/>
                <a:gd name="T79" fmla="*/ 398 h 442"/>
                <a:gd name="T80" fmla="*/ 401 w 515"/>
                <a:gd name="T81" fmla="*/ 420 h 442"/>
                <a:gd name="T82" fmla="*/ 515 w 515"/>
                <a:gd name="T83" fmla="*/ 420 h 442"/>
                <a:gd name="T84" fmla="*/ 515 w 515"/>
                <a:gd name="T85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515" h="442">
                  <a:moveTo>
                    <a:pt x="0" y="0"/>
                  </a:moveTo>
                  <a:lnTo>
                    <a:pt x="32" y="0"/>
                  </a:lnTo>
                  <a:lnTo>
                    <a:pt x="32" y="20"/>
                  </a:lnTo>
                  <a:lnTo>
                    <a:pt x="58" y="20"/>
                  </a:lnTo>
                  <a:lnTo>
                    <a:pt x="58" y="40"/>
                  </a:lnTo>
                  <a:lnTo>
                    <a:pt x="66" y="40"/>
                  </a:lnTo>
                  <a:lnTo>
                    <a:pt x="66" y="60"/>
                  </a:lnTo>
                  <a:lnTo>
                    <a:pt x="72" y="60"/>
                  </a:lnTo>
                  <a:lnTo>
                    <a:pt x="72" y="80"/>
                  </a:lnTo>
                  <a:lnTo>
                    <a:pt x="81" y="80"/>
                  </a:lnTo>
                  <a:lnTo>
                    <a:pt x="81" y="100"/>
                  </a:lnTo>
                  <a:lnTo>
                    <a:pt x="104" y="100"/>
                  </a:lnTo>
                  <a:lnTo>
                    <a:pt x="104" y="120"/>
                  </a:lnTo>
                  <a:lnTo>
                    <a:pt x="107" y="120"/>
                  </a:lnTo>
                  <a:lnTo>
                    <a:pt x="107" y="141"/>
                  </a:lnTo>
                  <a:lnTo>
                    <a:pt x="123" y="141"/>
                  </a:lnTo>
                  <a:lnTo>
                    <a:pt x="123" y="161"/>
                  </a:lnTo>
                  <a:lnTo>
                    <a:pt x="129" y="161"/>
                  </a:lnTo>
                  <a:lnTo>
                    <a:pt x="129" y="181"/>
                  </a:lnTo>
                  <a:lnTo>
                    <a:pt x="155" y="181"/>
                  </a:lnTo>
                  <a:lnTo>
                    <a:pt x="155" y="201"/>
                  </a:lnTo>
                  <a:lnTo>
                    <a:pt x="156" y="201"/>
                  </a:lnTo>
                  <a:lnTo>
                    <a:pt x="156" y="221"/>
                  </a:lnTo>
                  <a:lnTo>
                    <a:pt x="164" y="221"/>
                  </a:lnTo>
                  <a:lnTo>
                    <a:pt x="164" y="243"/>
                  </a:lnTo>
                  <a:lnTo>
                    <a:pt x="181" y="243"/>
                  </a:lnTo>
                  <a:lnTo>
                    <a:pt x="181" y="265"/>
                  </a:lnTo>
                  <a:lnTo>
                    <a:pt x="198" y="265"/>
                  </a:lnTo>
                  <a:lnTo>
                    <a:pt x="198" y="287"/>
                  </a:lnTo>
                  <a:lnTo>
                    <a:pt x="205" y="287"/>
                  </a:lnTo>
                  <a:lnTo>
                    <a:pt x="205" y="309"/>
                  </a:lnTo>
                  <a:lnTo>
                    <a:pt x="207" y="309"/>
                  </a:lnTo>
                  <a:lnTo>
                    <a:pt x="207" y="331"/>
                  </a:lnTo>
                  <a:lnTo>
                    <a:pt x="215" y="331"/>
                  </a:lnTo>
                  <a:lnTo>
                    <a:pt x="215" y="353"/>
                  </a:lnTo>
                  <a:lnTo>
                    <a:pt x="281" y="353"/>
                  </a:lnTo>
                  <a:lnTo>
                    <a:pt x="281" y="376"/>
                  </a:lnTo>
                  <a:lnTo>
                    <a:pt x="295" y="376"/>
                  </a:lnTo>
                  <a:lnTo>
                    <a:pt x="295" y="398"/>
                  </a:lnTo>
                  <a:lnTo>
                    <a:pt x="401" y="398"/>
                  </a:lnTo>
                  <a:lnTo>
                    <a:pt x="401" y="420"/>
                  </a:lnTo>
                  <a:lnTo>
                    <a:pt x="515" y="420"/>
                  </a:lnTo>
                  <a:lnTo>
                    <a:pt x="515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79" name="Line 40">
              <a:extLst>
                <a:ext uri="{FF2B5EF4-FFF2-40B4-BE49-F238E27FC236}">
                  <a16:creationId xmlns:a16="http://schemas.microsoft.com/office/drawing/2014/main" xmlns="" id="{56E680BA-257C-47B1-9958-4D77FDC2CB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76959" y="4820456"/>
              <a:ext cx="458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80" name="Line 41">
              <a:extLst>
                <a:ext uri="{FF2B5EF4-FFF2-40B4-BE49-F238E27FC236}">
                  <a16:creationId xmlns:a16="http://schemas.microsoft.com/office/drawing/2014/main" xmlns="" id="{062AA160-5DBC-4509-89DA-4246F0D277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02322" y="4798995"/>
              <a:ext cx="0" cy="4194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81" name="Line 42">
              <a:extLst>
                <a:ext uri="{FF2B5EF4-FFF2-40B4-BE49-F238E27FC236}">
                  <a16:creationId xmlns:a16="http://schemas.microsoft.com/office/drawing/2014/main" xmlns="" id="{BE1DFC01-E052-4676-834A-7CA238A5BB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7926" y="3979556"/>
              <a:ext cx="119989" cy="0"/>
            </a:xfrm>
            <a:prstGeom prst="line">
              <a:avLst/>
            </a:pr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82" name="Line 43">
              <a:extLst>
                <a:ext uri="{FF2B5EF4-FFF2-40B4-BE49-F238E27FC236}">
                  <a16:creationId xmlns:a16="http://schemas.microsoft.com/office/drawing/2014/main" xmlns="" id="{CB3A94EB-B5B6-4045-A76F-830AABAD60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3049" y="4100520"/>
              <a:ext cx="119989" cy="0"/>
            </a:xfrm>
            <a:prstGeom prst="line">
              <a:avLst/>
            </a:prstGeom>
            <a:noFill/>
            <a:ln w="19050" cap="rnd" cmpd="sng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448" name="図形グループ 447"/>
          <p:cNvGrpSpPr/>
          <p:nvPr/>
        </p:nvGrpSpPr>
        <p:grpSpPr>
          <a:xfrm>
            <a:off x="1184362" y="497125"/>
            <a:ext cx="2470340" cy="2200257"/>
            <a:chOff x="1171254" y="804749"/>
            <a:chExt cx="2624557" cy="2287741"/>
          </a:xfrm>
        </p:grpSpPr>
        <p:sp>
          <p:nvSpPr>
            <p:cNvPr id="89" name="Line 50">
              <a:extLst>
                <a:ext uri="{FF2B5EF4-FFF2-40B4-BE49-F238E27FC236}">
                  <a16:creationId xmlns:a16="http://schemas.microsoft.com/office/drawing/2014/main" xmlns="" id="{C4F31F16-5E26-4095-83C5-1E414E4A62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23458" y="2745371"/>
              <a:ext cx="199402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0" name="Line 51">
              <a:extLst>
                <a:ext uri="{FF2B5EF4-FFF2-40B4-BE49-F238E27FC236}">
                  <a16:creationId xmlns:a16="http://schemas.microsoft.com/office/drawing/2014/main" xmlns="" id="{FA4BAD75-88DC-42A8-A751-3FCC3FE728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23458" y="2745371"/>
              <a:ext cx="0" cy="3719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1" name="Line 52">
              <a:extLst>
                <a:ext uri="{FF2B5EF4-FFF2-40B4-BE49-F238E27FC236}">
                  <a16:creationId xmlns:a16="http://schemas.microsoft.com/office/drawing/2014/main" xmlns="" id="{DBCBE15B-CC54-4DA0-A514-0E39EE024E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7637" y="2745371"/>
              <a:ext cx="0" cy="3719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2" name="Line 53">
              <a:extLst>
                <a:ext uri="{FF2B5EF4-FFF2-40B4-BE49-F238E27FC236}">
                  <a16:creationId xmlns:a16="http://schemas.microsoft.com/office/drawing/2014/main" xmlns="" id="{A88027E1-D44A-4F70-BB57-7182D2863C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95632" y="2745371"/>
              <a:ext cx="0" cy="3719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3" name="Line 54">
              <a:extLst>
                <a:ext uri="{FF2B5EF4-FFF2-40B4-BE49-F238E27FC236}">
                  <a16:creationId xmlns:a16="http://schemas.microsoft.com/office/drawing/2014/main" xmlns="" id="{DAB660BF-56B4-45CC-B011-A9FB0BB9E2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9811" y="2745371"/>
              <a:ext cx="0" cy="3719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4" name="Line 55">
              <a:extLst>
                <a:ext uri="{FF2B5EF4-FFF2-40B4-BE49-F238E27FC236}">
                  <a16:creationId xmlns:a16="http://schemas.microsoft.com/office/drawing/2014/main" xmlns="" id="{3F3911EA-4BDB-45A3-A649-D64DE5865A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3991" y="2745371"/>
              <a:ext cx="0" cy="3719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5" name="Line 56">
              <a:extLst>
                <a:ext uri="{FF2B5EF4-FFF2-40B4-BE49-F238E27FC236}">
                  <a16:creationId xmlns:a16="http://schemas.microsoft.com/office/drawing/2014/main" xmlns="" id="{94DE6B09-8A41-4A0E-93C7-415B81A151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8171" y="2745371"/>
              <a:ext cx="0" cy="3719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6" name="Line 57">
              <a:extLst>
                <a:ext uri="{FF2B5EF4-FFF2-40B4-BE49-F238E27FC236}">
                  <a16:creationId xmlns:a16="http://schemas.microsoft.com/office/drawing/2014/main" xmlns="" id="{13542CF5-25AB-429B-A9FC-DE765A956E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3304" y="2745371"/>
              <a:ext cx="0" cy="3719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7" name="Line 58">
              <a:extLst>
                <a:ext uri="{FF2B5EF4-FFF2-40B4-BE49-F238E27FC236}">
                  <a16:creationId xmlns:a16="http://schemas.microsoft.com/office/drawing/2014/main" xmlns="" id="{7E178FF5-B6D9-427A-BCF3-1E15F6C252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7484" y="2745371"/>
              <a:ext cx="0" cy="3719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8" name="Rectangle 59">
              <a:extLst>
                <a:ext uri="{FF2B5EF4-FFF2-40B4-BE49-F238E27FC236}">
                  <a16:creationId xmlns:a16="http://schemas.microsoft.com/office/drawing/2014/main" xmlns="" id="{8E37B2B9-86B0-40E6-B112-A5345605B4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1035" y="2830244"/>
              <a:ext cx="63893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99" name="Rectangle 60">
              <a:extLst>
                <a:ext uri="{FF2B5EF4-FFF2-40B4-BE49-F238E27FC236}">
                  <a16:creationId xmlns:a16="http://schemas.microsoft.com/office/drawing/2014/main" xmlns="" id="{086A770A-3D8B-479E-9446-1E9F8752D9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214" y="2830244"/>
              <a:ext cx="63893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00" name="Rectangle 61">
              <a:extLst>
                <a:ext uri="{FF2B5EF4-FFF2-40B4-BE49-F238E27FC236}">
                  <a16:creationId xmlns:a16="http://schemas.microsoft.com/office/drawing/2014/main" xmlns="" id="{A5209ED2-9FC2-437A-A30D-609F888262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3208" y="2830244"/>
              <a:ext cx="63893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01" name="Rectangle 62">
              <a:extLst>
                <a:ext uri="{FF2B5EF4-FFF2-40B4-BE49-F238E27FC236}">
                  <a16:creationId xmlns:a16="http://schemas.microsoft.com/office/drawing/2014/main" xmlns="" id="{057B6F70-226C-427F-BBBB-450FC9532E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7388" y="2830244"/>
              <a:ext cx="63893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02" name="Rectangle 63">
              <a:extLst>
                <a:ext uri="{FF2B5EF4-FFF2-40B4-BE49-F238E27FC236}">
                  <a16:creationId xmlns:a16="http://schemas.microsoft.com/office/drawing/2014/main" xmlns="" id="{B2419509-8A17-4A29-A5C2-BA3284285E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1568" y="2830244"/>
              <a:ext cx="63893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03" name="Rectangle 64">
              <a:extLst>
                <a:ext uri="{FF2B5EF4-FFF2-40B4-BE49-F238E27FC236}">
                  <a16:creationId xmlns:a16="http://schemas.microsoft.com/office/drawing/2014/main" xmlns="" id="{518E2FD6-1CDC-4229-B375-86CE7485C6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5721" y="2830244"/>
              <a:ext cx="128739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04" name="Rectangle 65">
              <a:extLst>
                <a:ext uri="{FF2B5EF4-FFF2-40B4-BE49-F238E27FC236}">
                  <a16:creationId xmlns:a16="http://schemas.microsoft.com/office/drawing/2014/main" xmlns="" id="{C844AC7C-AE16-4D60-90CF-507B43DDF4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0855" y="2830244"/>
              <a:ext cx="128739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05" name="Rectangle 66">
              <a:extLst>
                <a:ext uri="{FF2B5EF4-FFF2-40B4-BE49-F238E27FC236}">
                  <a16:creationId xmlns:a16="http://schemas.microsoft.com/office/drawing/2014/main" xmlns="" id="{7046BCF2-6043-4232-B86D-CEEA00AD1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5034" y="2830244"/>
              <a:ext cx="128739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06" name="Line 67">
              <a:extLst>
                <a:ext uri="{FF2B5EF4-FFF2-40B4-BE49-F238E27FC236}">
                  <a16:creationId xmlns:a16="http://schemas.microsoft.com/office/drawing/2014/main" xmlns="" id="{836F60AD-D5E3-4219-9372-6448F0ECB7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23458" y="878178"/>
              <a:ext cx="0" cy="179471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07" name="Line 68">
              <a:extLst>
                <a:ext uri="{FF2B5EF4-FFF2-40B4-BE49-F238E27FC236}">
                  <a16:creationId xmlns:a16="http://schemas.microsoft.com/office/drawing/2014/main" xmlns="" id="{90CC90FB-01F7-44EC-8C1E-CD605DF16E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220" y="2672896"/>
              <a:ext cx="362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08" name="Line 69">
              <a:extLst>
                <a:ext uri="{FF2B5EF4-FFF2-40B4-BE49-F238E27FC236}">
                  <a16:creationId xmlns:a16="http://schemas.microsoft.com/office/drawing/2014/main" xmlns="" id="{E633CFE4-B45C-4D51-8F8D-FB1FD1F399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220" y="2311473"/>
              <a:ext cx="362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09" name="Line 70">
              <a:extLst>
                <a:ext uri="{FF2B5EF4-FFF2-40B4-BE49-F238E27FC236}">
                  <a16:creationId xmlns:a16="http://schemas.microsoft.com/office/drawing/2014/main" xmlns="" id="{5C5CB6AF-0702-440D-B851-A1CA55B939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220" y="1953864"/>
              <a:ext cx="362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10" name="Line 71">
              <a:extLst>
                <a:ext uri="{FF2B5EF4-FFF2-40B4-BE49-F238E27FC236}">
                  <a16:creationId xmlns:a16="http://schemas.microsoft.com/office/drawing/2014/main" xmlns="" id="{BC356575-0B71-4E90-9F95-D81594D0F0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220" y="1596256"/>
              <a:ext cx="362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11" name="Line 72">
              <a:extLst>
                <a:ext uri="{FF2B5EF4-FFF2-40B4-BE49-F238E27FC236}">
                  <a16:creationId xmlns:a16="http://schemas.microsoft.com/office/drawing/2014/main" xmlns="" id="{C314C83F-A528-4C98-85A8-9FFFAD916B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220" y="1234833"/>
              <a:ext cx="362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12" name="Line 73">
              <a:extLst>
                <a:ext uri="{FF2B5EF4-FFF2-40B4-BE49-F238E27FC236}">
                  <a16:creationId xmlns:a16="http://schemas.microsoft.com/office/drawing/2014/main" xmlns="" id="{E9959C00-645D-452C-AEBA-C5F484025D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220" y="878178"/>
              <a:ext cx="362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13" name="Rectangle 74">
              <a:extLst>
                <a:ext uri="{FF2B5EF4-FFF2-40B4-BE49-F238E27FC236}">
                  <a16:creationId xmlns:a16="http://schemas.microsoft.com/office/drawing/2014/main" xmlns="" id="{FC3EC61E-56C8-4227-9840-589067AD2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7580" y="2580395"/>
              <a:ext cx="63893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14" name="Rectangle 75">
              <a:extLst>
                <a:ext uri="{FF2B5EF4-FFF2-40B4-BE49-F238E27FC236}">
                  <a16:creationId xmlns:a16="http://schemas.microsoft.com/office/drawing/2014/main" xmlns="" id="{2AFA83C3-4249-4755-BFAD-E8603FFCB7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5130" y="2223740"/>
              <a:ext cx="128739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15" name="Rectangle 76">
              <a:extLst>
                <a:ext uri="{FF2B5EF4-FFF2-40B4-BE49-F238E27FC236}">
                  <a16:creationId xmlns:a16="http://schemas.microsoft.com/office/drawing/2014/main" xmlns="" id="{FA151011-52DC-4725-B864-3097781F4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5130" y="1866131"/>
              <a:ext cx="128739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16" name="Rectangle 77">
              <a:extLst>
                <a:ext uri="{FF2B5EF4-FFF2-40B4-BE49-F238E27FC236}">
                  <a16:creationId xmlns:a16="http://schemas.microsoft.com/office/drawing/2014/main" xmlns="" id="{E4AC01A3-0217-46B7-A228-A6F3106FA1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5130" y="1504708"/>
              <a:ext cx="128739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17" name="Rectangle 78">
              <a:extLst>
                <a:ext uri="{FF2B5EF4-FFF2-40B4-BE49-F238E27FC236}">
                  <a16:creationId xmlns:a16="http://schemas.microsoft.com/office/drawing/2014/main" xmlns="" id="{0EE48EE5-E7BD-42AB-B256-638F8FDB55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5130" y="1147100"/>
              <a:ext cx="128739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18" name="Rectangle 79">
              <a:extLst>
                <a:ext uri="{FF2B5EF4-FFF2-40B4-BE49-F238E27FC236}">
                  <a16:creationId xmlns:a16="http://schemas.microsoft.com/office/drawing/2014/main" xmlns="" id="{B6E027E1-B3D1-45AD-B7D5-553F540D7B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2681" y="807610"/>
              <a:ext cx="192632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119" name="Freeform 80">
              <a:extLst>
                <a:ext uri="{FF2B5EF4-FFF2-40B4-BE49-F238E27FC236}">
                  <a16:creationId xmlns:a16="http://schemas.microsoft.com/office/drawing/2014/main" xmlns="" id="{75353BF9-95B5-481B-99D6-489946A0E56D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3458" y="804749"/>
              <a:ext cx="2172353" cy="1940622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20" name="Rectangle 81">
              <a:extLst>
                <a:ext uri="{FF2B5EF4-FFF2-40B4-BE49-F238E27FC236}">
                  <a16:creationId xmlns:a16="http://schemas.microsoft.com/office/drawing/2014/main" xmlns="" id="{845AA5A3-92D7-4F23-BC26-50AAE124A0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1458" y="2954215"/>
              <a:ext cx="795322" cy="13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(months)</a:t>
              </a:r>
              <a:endParaRPr kumimoji="0" lang="ja-JP" altLang="ja-JP" b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21" name="Rectangle 82">
              <a:extLst>
                <a:ext uri="{FF2B5EF4-FFF2-40B4-BE49-F238E27FC236}">
                  <a16:creationId xmlns:a16="http://schemas.microsoft.com/office/drawing/2014/main" xmlns="" id="{84B469FA-DA9A-481C-B127-CBA7B0AAE88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6859" y="1683036"/>
              <a:ext cx="1782321" cy="1535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1000" b="1" dirty="0">
                  <a:solidFill>
                    <a:srgbClr val="000000"/>
                  </a:solidFill>
                  <a:latin typeface="Arial"/>
                  <a:cs typeface="Arial"/>
                </a:rPr>
                <a:t>Progression-free survival (%)</a:t>
              </a:r>
              <a:endParaRPr kumimoji="0" lang="ja-JP" altLang="ja-JP" sz="1000" b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22" name="Freeform 83">
              <a:extLst>
                <a:ext uri="{FF2B5EF4-FFF2-40B4-BE49-F238E27FC236}">
                  <a16:creationId xmlns:a16="http://schemas.microsoft.com/office/drawing/2014/main" xmlns="" id="{69AED9FE-48B8-4916-BCE4-80DAA5A36F1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3458" y="878178"/>
              <a:ext cx="803904" cy="1794718"/>
            </a:xfrm>
            <a:custGeom>
              <a:avLst/>
              <a:gdLst>
                <a:gd name="T0" fmla="*/ 0 w 198"/>
                <a:gd name="T1" fmla="*/ 0 h 442"/>
                <a:gd name="T2" fmla="*/ 52 w 198"/>
                <a:gd name="T3" fmla="*/ 0 h 442"/>
                <a:gd name="T4" fmla="*/ 52 w 198"/>
                <a:gd name="T5" fmla="*/ 44 h 442"/>
                <a:gd name="T6" fmla="*/ 72 w 198"/>
                <a:gd name="T7" fmla="*/ 44 h 442"/>
                <a:gd name="T8" fmla="*/ 72 w 198"/>
                <a:gd name="T9" fmla="*/ 88 h 442"/>
                <a:gd name="T10" fmla="*/ 74 w 198"/>
                <a:gd name="T11" fmla="*/ 88 h 442"/>
                <a:gd name="T12" fmla="*/ 74 w 198"/>
                <a:gd name="T13" fmla="*/ 132 h 442"/>
                <a:gd name="T14" fmla="*/ 76 w 198"/>
                <a:gd name="T15" fmla="*/ 132 h 442"/>
                <a:gd name="T16" fmla="*/ 76 w 198"/>
                <a:gd name="T17" fmla="*/ 177 h 442"/>
                <a:gd name="T18" fmla="*/ 107 w 198"/>
                <a:gd name="T19" fmla="*/ 177 h 442"/>
                <a:gd name="T20" fmla="*/ 107 w 198"/>
                <a:gd name="T21" fmla="*/ 221 h 442"/>
                <a:gd name="T22" fmla="*/ 129 w 198"/>
                <a:gd name="T23" fmla="*/ 221 h 442"/>
                <a:gd name="T24" fmla="*/ 129 w 198"/>
                <a:gd name="T25" fmla="*/ 265 h 442"/>
                <a:gd name="T26" fmla="*/ 156 w 198"/>
                <a:gd name="T27" fmla="*/ 265 h 442"/>
                <a:gd name="T28" fmla="*/ 156 w 198"/>
                <a:gd name="T29" fmla="*/ 309 h 442"/>
                <a:gd name="T30" fmla="*/ 164 w 198"/>
                <a:gd name="T31" fmla="*/ 309 h 442"/>
                <a:gd name="T32" fmla="*/ 164 w 198"/>
                <a:gd name="T33" fmla="*/ 353 h 442"/>
                <a:gd name="T34" fmla="*/ 181 w 198"/>
                <a:gd name="T35" fmla="*/ 353 h 442"/>
                <a:gd name="T36" fmla="*/ 181 w 198"/>
                <a:gd name="T37" fmla="*/ 398 h 442"/>
                <a:gd name="T38" fmla="*/ 198 w 198"/>
                <a:gd name="T39" fmla="*/ 398 h 442"/>
                <a:gd name="T40" fmla="*/ 198 w 198"/>
                <a:gd name="T41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98" h="442">
                  <a:moveTo>
                    <a:pt x="0" y="0"/>
                  </a:moveTo>
                  <a:lnTo>
                    <a:pt x="52" y="0"/>
                  </a:lnTo>
                  <a:lnTo>
                    <a:pt x="52" y="44"/>
                  </a:lnTo>
                  <a:lnTo>
                    <a:pt x="72" y="44"/>
                  </a:lnTo>
                  <a:lnTo>
                    <a:pt x="72" y="88"/>
                  </a:lnTo>
                  <a:lnTo>
                    <a:pt x="74" y="88"/>
                  </a:lnTo>
                  <a:lnTo>
                    <a:pt x="74" y="132"/>
                  </a:lnTo>
                  <a:lnTo>
                    <a:pt x="76" y="132"/>
                  </a:lnTo>
                  <a:lnTo>
                    <a:pt x="76" y="177"/>
                  </a:lnTo>
                  <a:lnTo>
                    <a:pt x="107" y="177"/>
                  </a:lnTo>
                  <a:lnTo>
                    <a:pt x="107" y="221"/>
                  </a:lnTo>
                  <a:lnTo>
                    <a:pt x="129" y="221"/>
                  </a:lnTo>
                  <a:lnTo>
                    <a:pt x="129" y="265"/>
                  </a:lnTo>
                  <a:lnTo>
                    <a:pt x="156" y="265"/>
                  </a:lnTo>
                  <a:lnTo>
                    <a:pt x="156" y="309"/>
                  </a:lnTo>
                  <a:lnTo>
                    <a:pt x="164" y="309"/>
                  </a:lnTo>
                  <a:lnTo>
                    <a:pt x="164" y="353"/>
                  </a:lnTo>
                  <a:lnTo>
                    <a:pt x="181" y="353"/>
                  </a:lnTo>
                  <a:lnTo>
                    <a:pt x="181" y="398"/>
                  </a:lnTo>
                  <a:lnTo>
                    <a:pt x="198" y="398"/>
                  </a:lnTo>
                  <a:lnTo>
                    <a:pt x="198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24" name="Freeform 84">
              <a:extLst>
                <a:ext uri="{FF2B5EF4-FFF2-40B4-BE49-F238E27FC236}">
                  <a16:creationId xmlns:a16="http://schemas.microsoft.com/office/drawing/2014/main" xmlns="" id="{A8B8156F-F523-4494-9E5F-3846D920C08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3458" y="878178"/>
              <a:ext cx="2091295" cy="1794718"/>
            </a:xfrm>
            <a:custGeom>
              <a:avLst/>
              <a:gdLst>
                <a:gd name="T0" fmla="*/ 0 w 515"/>
                <a:gd name="T1" fmla="*/ 0 h 442"/>
                <a:gd name="T2" fmla="*/ 32 w 515"/>
                <a:gd name="T3" fmla="*/ 0 h 442"/>
                <a:gd name="T4" fmla="*/ 32 w 515"/>
                <a:gd name="T5" fmla="*/ 28 h 442"/>
                <a:gd name="T6" fmla="*/ 58 w 515"/>
                <a:gd name="T7" fmla="*/ 28 h 442"/>
                <a:gd name="T8" fmla="*/ 58 w 515"/>
                <a:gd name="T9" fmla="*/ 55 h 442"/>
                <a:gd name="T10" fmla="*/ 66 w 515"/>
                <a:gd name="T11" fmla="*/ 55 h 442"/>
                <a:gd name="T12" fmla="*/ 66 w 515"/>
                <a:gd name="T13" fmla="*/ 83 h 442"/>
                <a:gd name="T14" fmla="*/ 81 w 515"/>
                <a:gd name="T15" fmla="*/ 83 h 442"/>
                <a:gd name="T16" fmla="*/ 81 w 515"/>
                <a:gd name="T17" fmla="*/ 110 h 442"/>
                <a:gd name="T18" fmla="*/ 104 w 515"/>
                <a:gd name="T19" fmla="*/ 110 h 442"/>
                <a:gd name="T20" fmla="*/ 104 w 515"/>
                <a:gd name="T21" fmla="*/ 138 h 442"/>
                <a:gd name="T22" fmla="*/ 123 w 515"/>
                <a:gd name="T23" fmla="*/ 138 h 442"/>
                <a:gd name="T24" fmla="*/ 123 w 515"/>
                <a:gd name="T25" fmla="*/ 166 h 442"/>
                <a:gd name="T26" fmla="*/ 155 w 515"/>
                <a:gd name="T27" fmla="*/ 166 h 442"/>
                <a:gd name="T28" fmla="*/ 155 w 515"/>
                <a:gd name="T29" fmla="*/ 193 h 442"/>
                <a:gd name="T30" fmla="*/ 164 w 515"/>
                <a:gd name="T31" fmla="*/ 193 h 442"/>
                <a:gd name="T32" fmla="*/ 164 w 515"/>
                <a:gd name="T33" fmla="*/ 224 h 442"/>
                <a:gd name="T34" fmla="*/ 205 w 515"/>
                <a:gd name="T35" fmla="*/ 224 h 442"/>
                <a:gd name="T36" fmla="*/ 205 w 515"/>
                <a:gd name="T37" fmla="*/ 255 h 442"/>
                <a:gd name="T38" fmla="*/ 207 w 515"/>
                <a:gd name="T39" fmla="*/ 255 h 442"/>
                <a:gd name="T40" fmla="*/ 207 w 515"/>
                <a:gd name="T41" fmla="*/ 287 h 442"/>
                <a:gd name="T42" fmla="*/ 215 w 515"/>
                <a:gd name="T43" fmla="*/ 287 h 442"/>
                <a:gd name="T44" fmla="*/ 215 w 515"/>
                <a:gd name="T45" fmla="*/ 318 h 442"/>
                <a:gd name="T46" fmla="*/ 281 w 515"/>
                <a:gd name="T47" fmla="*/ 318 h 442"/>
                <a:gd name="T48" fmla="*/ 281 w 515"/>
                <a:gd name="T49" fmla="*/ 349 h 442"/>
                <a:gd name="T50" fmla="*/ 295 w 515"/>
                <a:gd name="T51" fmla="*/ 349 h 442"/>
                <a:gd name="T52" fmla="*/ 295 w 515"/>
                <a:gd name="T53" fmla="*/ 380 h 442"/>
                <a:gd name="T54" fmla="*/ 401 w 515"/>
                <a:gd name="T55" fmla="*/ 380 h 442"/>
                <a:gd name="T56" fmla="*/ 401 w 515"/>
                <a:gd name="T57" fmla="*/ 411 h 442"/>
                <a:gd name="T58" fmla="*/ 515 w 515"/>
                <a:gd name="T59" fmla="*/ 411 h 442"/>
                <a:gd name="T60" fmla="*/ 515 w 515"/>
                <a:gd name="T61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515" h="442">
                  <a:moveTo>
                    <a:pt x="0" y="0"/>
                  </a:moveTo>
                  <a:lnTo>
                    <a:pt x="32" y="0"/>
                  </a:lnTo>
                  <a:lnTo>
                    <a:pt x="32" y="28"/>
                  </a:lnTo>
                  <a:lnTo>
                    <a:pt x="58" y="28"/>
                  </a:lnTo>
                  <a:lnTo>
                    <a:pt x="58" y="55"/>
                  </a:lnTo>
                  <a:lnTo>
                    <a:pt x="66" y="55"/>
                  </a:lnTo>
                  <a:lnTo>
                    <a:pt x="66" y="83"/>
                  </a:lnTo>
                  <a:lnTo>
                    <a:pt x="81" y="83"/>
                  </a:lnTo>
                  <a:lnTo>
                    <a:pt x="81" y="110"/>
                  </a:lnTo>
                  <a:lnTo>
                    <a:pt x="104" y="110"/>
                  </a:lnTo>
                  <a:lnTo>
                    <a:pt x="104" y="138"/>
                  </a:lnTo>
                  <a:lnTo>
                    <a:pt x="123" y="138"/>
                  </a:lnTo>
                  <a:lnTo>
                    <a:pt x="123" y="166"/>
                  </a:lnTo>
                  <a:lnTo>
                    <a:pt x="155" y="166"/>
                  </a:lnTo>
                  <a:lnTo>
                    <a:pt x="155" y="193"/>
                  </a:lnTo>
                  <a:lnTo>
                    <a:pt x="164" y="193"/>
                  </a:lnTo>
                  <a:lnTo>
                    <a:pt x="164" y="224"/>
                  </a:lnTo>
                  <a:lnTo>
                    <a:pt x="205" y="224"/>
                  </a:lnTo>
                  <a:lnTo>
                    <a:pt x="205" y="255"/>
                  </a:lnTo>
                  <a:lnTo>
                    <a:pt x="207" y="255"/>
                  </a:lnTo>
                  <a:lnTo>
                    <a:pt x="207" y="287"/>
                  </a:lnTo>
                  <a:lnTo>
                    <a:pt x="215" y="287"/>
                  </a:lnTo>
                  <a:lnTo>
                    <a:pt x="215" y="318"/>
                  </a:lnTo>
                  <a:lnTo>
                    <a:pt x="281" y="318"/>
                  </a:lnTo>
                  <a:lnTo>
                    <a:pt x="281" y="349"/>
                  </a:lnTo>
                  <a:lnTo>
                    <a:pt x="295" y="349"/>
                  </a:lnTo>
                  <a:lnTo>
                    <a:pt x="295" y="380"/>
                  </a:lnTo>
                  <a:lnTo>
                    <a:pt x="401" y="380"/>
                  </a:lnTo>
                  <a:lnTo>
                    <a:pt x="401" y="411"/>
                  </a:lnTo>
                  <a:lnTo>
                    <a:pt x="515" y="411"/>
                  </a:lnTo>
                  <a:lnTo>
                    <a:pt x="515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25" name="Line 85">
              <a:extLst>
                <a:ext uri="{FF2B5EF4-FFF2-40B4-BE49-F238E27FC236}">
                  <a16:creationId xmlns:a16="http://schemas.microsoft.com/office/drawing/2014/main" xmlns="" id="{2261E62C-C897-48EA-BB02-8306FD2BBE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6663" y="1661102"/>
              <a:ext cx="4482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26" name="Line 86">
              <a:extLst>
                <a:ext uri="{FF2B5EF4-FFF2-40B4-BE49-F238E27FC236}">
                  <a16:creationId xmlns:a16="http://schemas.microsoft.com/office/drawing/2014/main" xmlns="" id="{3D768C79-1B1E-4330-9F84-EC2C08611D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81458" y="1641076"/>
              <a:ext cx="0" cy="4100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27" name="Line 87">
              <a:extLst>
                <a:ext uri="{FF2B5EF4-FFF2-40B4-BE49-F238E27FC236}">
                  <a16:creationId xmlns:a16="http://schemas.microsoft.com/office/drawing/2014/main" xmlns="" id="{48E8676B-E7C6-4DCD-84AF-38C8B875F6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0353" y="956375"/>
              <a:ext cx="118249" cy="0"/>
            </a:xfrm>
            <a:prstGeom prst="line">
              <a:avLst/>
            </a:pr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60" name="Line 88">
              <a:extLst>
                <a:ext uri="{FF2B5EF4-FFF2-40B4-BE49-F238E27FC236}">
                  <a16:creationId xmlns:a16="http://schemas.microsoft.com/office/drawing/2014/main" xmlns="" id="{E0BCA0AD-C688-4E24-9CDD-7C40750A91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2750" y="1061274"/>
              <a:ext cx="118249" cy="0"/>
            </a:xfrm>
            <a:prstGeom prst="line">
              <a:avLst/>
            </a:prstGeom>
            <a:noFill/>
            <a:ln w="19050" cap="rnd" cmpd="sng">
              <a:solidFill>
                <a:schemeClr val="tx1"/>
              </a:solidFill>
              <a:prstDash val="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0" name="図形グループ 9"/>
          <p:cNvGrpSpPr/>
          <p:nvPr/>
        </p:nvGrpSpPr>
        <p:grpSpPr>
          <a:xfrm>
            <a:off x="4976888" y="453637"/>
            <a:ext cx="2785513" cy="2260073"/>
            <a:chOff x="4991395" y="702153"/>
            <a:chExt cx="2835851" cy="2420777"/>
          </a:xfrm>
        </p:grpSpPr>
        <p:sp>
          <p:nvSpPr>
            <p:cNvPr id="233" name="Line 5">
              <a:extLst>
                <a:ext uri="{FF2B5EF4-FFF2-40B4-BE49-F238E27FC236}">
                  <a16:creationId xmlns:a16="http://schemas.microsoft.com/office/drawing/2014/main" xmlns="" id="{98E617BB-DEA0-4CFC-9728-AAEDB30958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04557" y="2762693"/>
              <a:ext cx="210698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34" name="Line 6">
              <a:extLst>
                <a:ext uri="{FF2B5EF4-FFF2-40B4-BE49-F238E27FC236}">
                  <a16:creationId xmlns:a16="http://schemas.microsoft.com/office/drawing/2014/main" xmlns="" id="{73690F34-ABF9-453D-9B7A-C8D7228DCE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04557" y="2762693"/>
              <a:ext cx="0" cy="3859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35" name="Line 7">
              <a:extLst>
                <a:ext uri="{FF2B5EF4-FFF2-40B4-BE49-F238E27FC236}">
                  <a16:creationId xmlns:a16="http://schemas.microsoft.com/office/drawing/2014/main" xmlns="" id="{B1D507DB-312A-40D9-B169-2422CEAE24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08383" y="2762693"/>
              <a:ext cx="0" cy="3859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36" name="Line 8">
              <a:extLst>
                <a:ext uri="{FF2B5EF4-FFF2-40B4-BE49-F238E27FC236}">
                  <a16:creationId xmlns:a16="http://schemas.microsoft.com/office/drawing/2014/main" xmlns="" id="{0D0AF78E-6F6F-4C87-BD1F-68926A6A85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07260" y="2762693"/>
              <a:ext cx="0" cy="3859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37" name="Line 9">
              <a:extLst>
                <a:ext uri="{FF2B5EF4-FFF2-40B4-BE49-F238E27FC236}">
                  <a16:creationId xmlns:a16="http://schemas.microsoft.com/office/drawing/2014/main" xmlns="" id="{9B96D377-7241-4FE2-942A-23A135C5BF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6138" y="2762693"/>
              <a:ext cx="0" cy="3859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38" name="Line 10">
              <a:extLst>
                <a:ext uri="{FF2B5EF4-FFF2-40B4-BE49-F238E27FC236}">
                  <a16:creationId xmlns:a16="http://schemas.microsoft.com/office/drawing/2014/main" xmlns="" id="{2F921457-1F0C-4420-B2EA-976B9D85AC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09963" y="2762693"/>
              <a:ext cx="0" cy="3859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39" name="Line 11">
              <a:extLst>
                <a:ext uri="{FF2B5EF4-FFF2-40B4-BE49-F238E27FC236}">
                  <a16:creationId xmlns:a16="http://schemas.microsoft.com/office/drawing/2014/main" xmlns="" id="{1406FCCA-72C5-40E8-8F8E-DEB728681F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08841" y="2762693"/>
              <a:ext cx="0" cy="3859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40" name="Line 12">
              <a:extLst>
                <a:ext uri="{FF2B5EF4-FFF2-40B4-BE49-F238E27FC236}">
                  <a16:creationId xmlns:a16="http://schemas.microsoft.com/office/drawing/2014/main" xmlns="" id="{FC62A3FC-3080-46D2-A025-C5C67048C5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07718" y="2762693"/>
              <a:ext cx="0" cy="3859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41" name="Line 13">
              <a:extLst>
                <a:ext uri="{FF2B5EF4-FFF2-40B4-BE49-F238E27FC236}">
                  <a16:creationId xmlns:a16="http://schemas.microsoft.com/office/drawing/2014/main" xmlns="" id="{11AC0C42-F273-46F7-BD30-3259EA8EF3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11544" y="2762693"/>
              <a:ext cx="0" cy="3859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42" name="Rectangle 14">
              <a:extLst>
                <a:ext uri="{FF2B5EF4-FFF2-40B4-BE49-F238E27FC236}">
                  <a16:creationId xmlns:a16="http://schemas.microsoft.com/office/drawing/2014/main" xmlns="" id="{4BF16159-BA89-4A13-A930-1D3AC7AF4C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0908" y="2850773"/>
              <a:ext cx="63338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3" name="Rectangle 15">
              <a:extLst>
                <a:ext uri="{FF2B5EF4-FFF2-40B4-BE49-F238E27FC236}">
                  <a16:creationId xmlns:a16="http://schemas.microsoft.com/office/drawing/2014/main" xmlns="" id="{8023E58D-1E7A-49EE-8678-2EA1BF0935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74734" y="2850773"/>
              <a:ext cx="63338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4" name="Rectangle 16">
              <a:extLst>
                <a:ext uri="{FF2B5EF4-FFF2-40B4-BE49-F238E27FC236}">
                  <a16:creationId xmlns:a16="http://schemas.microsoft.com/office/drawing/2014/main" xmlns="" id="{A4A6C51C-EA25-4ACA-8CB2-BF25963A25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3612" y="2850773"/>
              <a:ext cx="63338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5" name="Rectangle 17">
              <a:extLst>
                <a:ext uri="{FF2B5EF4-FFF2-40B4-BE49-F238E27FC236}">
                  <a16:creationId xmlns:a16="http://schemas.microsoft.com/office/drawing/2014/main" xmlns="" id="{9FA49860-58B9-4722-96A4-AEA7E13F03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2489" y="2850773"/>
              <a:ext cx="63338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6" name="Rectangle 18">
              <a:extLst>
                <a:ext uri="{FF2B5EF4-FFF2-40B4-BE49-F238E27FC236}">
                  <a16:creationId xmlns:a16="http://schemas.microsoft.com/office/drawing/2014/main" xmlns="" id="{5B288CEB-412F-4F78-AFE4-1602AF5D12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6315" y="2850773"/>
              <a:ext cx="63338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7" name="Rectangle 19">
              <a:extLst>
                <a:ext uri="{FF2B5EF4-FFF2-40B4-BE49-F238E27FC236}">
                  <a16:creationId xmlns:a16="http://schemas.microsoft.com/office/drawing/2014/main" xmlns="" id="{D87689C2-0B17-4F73-B934-5C278B9DE8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54410" y="2850773"/>
              <a:ext cx="126677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8" name="Rectangle 20">
              <a:extLst>
                <a:ext uri="{FF2B5EF4-FFF2-40B4-BE49-F238E27FC236}">
                  <a16:creationId xmlns:a16="http://schemas.microsoft.com/office/drawing/2014/main" xmlns="" id="{FA6D8293-09B1-418B-9AF7-61B1EBE5B8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53287" y="2850773"/>
              <a:ext cx="126677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9" name="Rectangle 21">
              <a:extLst>
                <a:ext uri="{FF2B5EF4-FFF2-40B4-BE49-F238E27FC236}">
                  <a16:creationId xmlns:a16="http://schemas.microsoft.com/office/drawing/2014/main" xmlns="" id="{9F4A3BBA-571E-4CC5-83C1-7242E94A50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7113" y="2850773"/>
              <a:ext cx="126677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0" name="Line 22">
              <a:extLst>
                <a:ext uri="{FF2B5EF4-FFF2-40B4-BE49-F238E27FC236}">
                  <a16:creationId xmlns:a16="http://schemas.microsoft.com/office/drawing/2014/main" xmlns="" id="{DE452414-6F5F-498C-A95C-E40947502B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04557" y="824936"/>
              <a:ext cx="0" cy="18625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51" name="Line 23">
              <a:extLst>
                <a:ext uri="{FF2B5EF4-FFF2-40B4-BE49-F238E27FC236}">
                  <a16:creationId xmlns:a16="http://schemas.microsoft.com/office/drawing/2014/main" xmlns="" id="{D6455115-279E-4E58-87A4-1586819BCD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66950" y="2687479"/>
              <a:ext cx="3760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52" name="Line 24">
              <a:extLst>
                <a:ext uri="{FF2B5EF4-FFF2-40B4-BE49-F238E27FC236}">
                  <a16:creationId xmlns:a16="http://schemas.microsoft.com/office/drawing/2014/main" xmlns="" id="{FD2F57D4-EE56-4DC6-A286-453696C186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66950" y="2312397"/>
              <a:ext cx="3760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53" name="Line 25">
              <a:extLst>
                <a:ext uri="{FF2B5EF4-FFF2-40B4-BE49-F238E27FC236}">
                  <a16:creationId xmlns:a16="http://schemas.microsoft.com/office/drawing/2014/main" xmlns="" id="{CFFA8501-8065-40F5-BA20-574DE01F05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66950" y="1941274"/>
              <a:ext cx="3760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54" name="Line 26">
              <a:extLst>
                <a:ext uri="{FF2B5EF4-FFF2-40B4-BE49-F238E27FC236}">
                  <a16:creationId xmlns:a16="http://schemas.microsoft.com/office/drawing/2014/main" xmlns="" id="{05E4B92D-E00E-4CAC-BB6D-E9006F597A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66950" y="1570151"/>
              <a:ext cx="3760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55" name="Line 27">
              <a:extLst>
                <a:ext uri="{FF2B5EF4-FFF2-40B4-BE49-F238E27FC236}">
                  <a16:creationId xmlns:a16="http://schemas.microsoft.com/office/drawing/2014/main" xmlns="" id="{7ADFDCBF-F2C1-4391-BE00-6DE9AA4DCB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66950" y="1195069"/>
              <a:ext cx="3760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56" name="Line 28">
              <a:extLst>
                <a:ext uri="{FF2B5EF4-FFF2-40B4-BE49-F238E27FC236}">
                  <a16:creationId xmlns:a16="http://schemas.microsoft.com/office/drawing/2014/main" xmlns="" id="{2C122572-9B49-4E3D-AC70-2710C8546A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66950" y="824936"/>
              <a:ext cx="3760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57" name="Rectangle 29">
              <a:extLst>
                <a:ext uri="{FF2B5EF4-FFF2-40B4-BE49-F238E27FC236}">
                  <a16:creationId xmlns:a16="http://schemas.microsoft.com/office/drawing/2014/main" xmlns="" id="{CD8EC774-A995-41C7-B37D-1D0C6A33AF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6787" y="2617213"/>
              <a:ext cx="63338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8" name="Rectangle 30">
              <a:extLst>
                <a:ext uri="{FF2B5EF4-FFF2-40B4-BE49-F238E27FC236}">
                  <a16:creationId xmlns:a16="http://schemas.microsoft.com/office/drawing/2014/main" xmlns="" id="{344919E1-89B8-4243-8A27-8BBDCE4414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7201" y="2237183"/>
              <a:ext cx="126677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9" name="Rectangle 31">
              <a:extLst>
                <a:ext uri="{FF2B5EF4-FFF2-40B4-BE49-F238E27FC236}">
                  <a16:creationId xmlns:a16="http://schemas.microsoft.com/office/drawing/2014/main" xmlns="" id="{0587E539-332D-4BF5-B96A-25AD2D83CA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7201" y="1866060"/>
              <a:ext cx="126677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60" name="Rectangle 32">
              <a:extLst>
                <a:ext uri="{FF2B5EF4-FFF2-40B4-BE49-F238E27FC236}">
                  <a16:creationId xmlns:a16="http://schemas.microsoft.com/office/drawing/2014/main" xmlns="" id="{1718E55B-EC9A-4B55-BE82-2FB6A280CC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7201" y="1490978"/>
              <a:ext cx="126677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61" name="Rectangle 33">
              <a:extLst>
                <a:ext uri="{FF2B5EF4-FFF2-40B4-BE49-F238E27FC236}">
                  <a16:creationId xmlns:a16="http://schemas.microsoft.com/office/drawing/2014/main" xmlns="" id="{0D140317-4AFF-41C2-99BF-4B2F2926CB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7201" y="1119855"/>
              <a:ext cx="126677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62" name="Rectangle 34">
              <a:extLst>
                <a:ext uri="{FF2B5EF4-FFF2-40B4-BE49-F238E27FC236}">
                  <a16:creationId xmlns:a16="http://schemas.microsoft.com/office/drawing/2014/main" xmlns="" id="{49BEB6D9-CE0B-4E01-A176-3A5A8E2362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7821" y="755660"/>
              <a:ext cx="189025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63" name="Freeform 35">
              <a:extLst>
                <a:ext uri="{FF2B5EF4-FFF2-40B4-BE49-F238E27FC236}">
                  <a16:creationId xmlns:a16="http://schemas.microsoft.com/office/drawing/2014/main" xmlns="" id="{808F97BF-C70E-4195-9F12-8457F071FBCD}"/>
                </a:ext>
              </a:extLst>
            </p:cNvPr>
            <p:cNvSpPr>
              <a:spLocks/>
            </p:cNvSpPr>
            <p:nvPr/>
          </p:nvSpPr>
          <p:spPr bwMode="auto">
            <a:xfrm>
              <a:off x="5404557" y="748732"/>
              <a:ext cx="2254447" cy="2013961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64" name="Rectangle 36">
              <a:extLst>
                <a:ext uri="{FF2B5EF4-FFF2-40B4-BE49-F238E27FC236}">
                  <a16:creationId xmlns:a16="http://schemas.microsoft.com/office/drawing/2014/main" xmlns="" id="{D27A7C15-6BEC-42CD-96E4-8EEA76B4B9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0140" y="2986357"/>
              <a:ext cx="781832" cy="1365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(months)</a:t>
              </a:r>
              <a:endParaRPr kumimoji="0" lang="ja-JP" altLang="ja-JP" sz="900" b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65" name="Rectangle 37">
              <a:extLst>
                <a:ext uri="{FF2B5EF4-FFF2-40B4-BE49-F238E27FC236}">
                  <a16:creationId xmlns:a16="http://schemas.microsoft.com/office/drawing/2014/main" xmlns="" id="{9E67D077-EA9A-409E-90B7-0832A02DDE4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481719" y="1618645"/>
              <a:ext cx="1170770" cy="1514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1000" b="1" dirty="0">
                  <a:solidFill>
                    <a:srgbClr val="000000"/>
                  </a:solidFill>
                  <a:latin typeface="Arial"/>
                  <a:cs typeface="Arial"/>
                </a:rPr>
                <a:t>Overall survival (%)</a:t>
              </a:r>
              <a:endParaRPr kumimoji="0" lang="ja-JP" altLang="ja-JP" sz="1000" b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66" name="Freeform 38">
              <a:extLst>
                <a:ext uri="{FF2B5EF4-FFF2-40B4-BE49-F238E27FC236}">
                  <a16:creationId xmlns:a16="http://schemas.microsoft.com/office/drawing/2014/main" xmlns="" id="{E077B4BF-E69B-4E71-B26B-7D9B2DEB1FDD}"/>
                </a:ext>
              </a:extLst>
            </p:cNvPr>
            <p:cNvSpPr>
              <a:spLocks/>
            </p:cNvSpPr>
            <p:nvPr/>
          </p:nvSpPr>
          <p:spPr bwMode="auto">
            <a:xfrm>
              <a:off x="5404557" y="824936"/>
              <a:ext cx="2376175" cy="1575541"/>
            </a:xfrm>
            <a:custGeom>
              <a:avLst/>
              <a:gdLst>
                <a:gd name="T0" fmla="*/ 0 w 564"/>
                <a:gd name="T1" fmla="*/ 0 h 374"/>
                <a:gd name="T2" fmla="*/ 77 w 564"/>
                <a:gd name="T3" fmla="*/ 0 h 374"/>
                <a:gd name="T4" fmla="*/ 77 w 564"/>
                <a:gd name="T5" fmla="*/ 44 h 374"/>
                <a:gd name="T6" fmla="*/ 215 w 564"/>
                <a:gd name="T7" fmla="*/ 44 h 374"/>
                <a:gd name="T8" fmla="*/ 215 w 564"/>
                <a:gd name="T9" fmla="*/ 101 h 374"/>
                <a:gd name="T10" fmla="*/ 267 w 564"/>
                <a:gd name="T11" fmla="*/ 101 h 374"/>
                <a:gd name="T12" fmla="*/ 267 w 564"/>
                <a:gd name="T13" fmla="*/ 169 h 374"/>
                <a:gd name="T14" fmla="*/ 289 w 564"/>
                <a:gd name="T15" fmla="*/ 169 h 374"/>
                <a:gd name="T16" fmla="*/ 289 w 564"/>
                <a:gd name="T17" fmla="*/ 237 h 374"/>
                <a:gd name="T18" fmla="*/ 346 w 564"/>
                <a:gd name="T19" fmla="*/ 237 h 374"/>
                <a:gd name="T20" fmla="*/ 346 w 564"/>
                <a:gd name="T21" fmla="*/ 306 h 374"/>
                <a:gd name="T22" fmla="*/ 353 w 564"/>
                <a:gd name="T23" fmla="*/ 306 h 374"/>
                <a:gd name="T24" fmla="*/ 353 w 564"/>
                <a:gd name="T25" fmla="*/ 374 h 374"/>
                <a:gd name="T26" fmla="*/ 564 w 564"/>
                <a:gd name="T27" fmla="*/ 374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564" h="374">
                  <a:moveTo>
                    <a:pt x="0" y="0"/>
                  </a:moveTo>
                  <a:lnTo>
                    <a:pt x="77" y="0"/>
                  </a:lnTo>
                  <a:lnTo>
                    <a:pt x="77" y="44"/>
                  </a:lnTo>
                  <a:lnTo>
                    <a:pt x="215" y="44"/>
                  </a:lnTo>
                  <a:lnTo>
                    <a:pt x="215" y="101"/>
                  </a:lnTo>
                  <a:lnTo>
                    <a:pt x="267" y="101"/>
                  </a:lnTo>
                  <a:lnTo>
                    <a:pt x="267" y="169"/>
                  </a:lnTo>
                  <a:lnTo>
                    <a:pt x="289" y="169"/>
                  </a:lnTo>
                  <a:lnTo>
                    <a:pt x="289" y="237"/>
                  </a:lnTo>
                  <a:lnTo>
                    <a:pt x="346" y="237"/>
                  </a:lnTo>
                  <a:lnTo>
                    <a:pt x="346" y="306"/>
                  </a:lnTo>
                  <a:lnTo>
                    <a:pt x="353" y="306"/>
                  </a:lnTo>
                  <a:lnTo>
                    <a:pt x="353" y="374"/>
                  </a:lnTo>
                  <a:lnTo>
                    <a:pt x="564" y="374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67" name="Line 39">
              <a:extLst>
                <a:ext uri="{FF2B5EF4-FFF2-40B4-BE49-F238E27FC236}">
                  <a16:creationId xmlns:a16="http://schemas.microsoft.com/office/drawing/2014/main" xmlns="" id="{06877B5A-0156-4D8B-A437-4CA48CB867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48826" y="1010003"/>
              <a:ext cx="4255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68" name="Line 40">
              <a:extLst>
                <a:ext uri="{FF2B5EF4-FFF2-40B4-BE49-F238E27FC236}">
                  <a16:creationId xmlns:a16="http://schemas.microsoft.com/office/drawing/2014/main" xmlns="" id="{13E2DE02-B7C1-41AF-9F30-C3784E506E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70598" y="989220"/>
              <a:ext cx="0" cy="4156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69" name="Line 41">
              <a:extLst>
                <a:ext uri="{FF2B5EF4-FFF2-40B4-BE49-F238E27FC236}">
                  <a16:creationId xmlns:a16="http://schemas.microsoft.com/office/drawing/2014/main" xmlns="" id="{24BB5002-736E-4AB7-B696-C554F81F3C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7423" y="1010003"/>
              <a:ext cx="4156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0" name="Line 42">
              <a:extLst>
                <a:ext uri="{FF2B5EF4-FFF2-40B4-BE49-F238E27FC236}">
                  <a16:creationId xmlns:a16="http://schemas.microsoft.com/office/drawing/2014/main" xmlns="" id="{09D29CF3-AA43-493B-8F88-58B476A292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08205" y="989220"/>
              <a:ext cx="0" cy="4156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1" name="Line 43">
              <a:extLst>
                <a:ext uri="{FF2B5EF4-FFF2-40B4-BE49-F238E27FC236}">
                  <a16:creationId xmlns:a16="http://schemas.microsoft.com/office/drawing/2014/main" xmlns="" id="{1C979A62-7373-4094-8EE1-77436082C0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15045" y="1250490"/>
              <a:ext cx="4156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2" name="Line 44">
              <a:extLst>
                <a:ext uri="{FF2B5EF4-FFF2-40B4-BE49-F238E27FC236}">
                  <a16:creationId xmlns:a16="http://schemas.microsoft.com/office/drawing/2014/main" xmlns="" id="{2A4B87D8-92DD-4ED0-A200-5406088461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35827" y="1228718"/>
              <a:ext cx="0" cy="4255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3" name="Line 45">
              <a:extLst>
                <a:ext uri="{FF2B5EF4-FFF2-40B4-BE49-F238E27FC236}">
                  <a16:creationId xmlns:a16="http://schemas.microsoft.com/office/drawing/2014/main" xmlns="" id="{7F8226E0-16A3-421D-A665-CB6B72FE1D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59949" y="2400477"/>
              <a:ext cx="4255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4" name="Line 46">
              <a:extLst>
                <a:ext uri="{FF2B5EF4-FFF2-40B4-BE49-F238E27FC236}">
                  <a16:creationId xmlns:a16="http://schemas.microsoft.com/office/drawing/2014/main" xmlns="" id="{325FAE00-AFB9-42E9-875C-E549E12190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80732" y="2379694"/>
              <a:ext cx="0" cy="4156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5" name="Freeform 47">
              <a:extLst>
                <a:ext uri="{FF2B5EF4-FFF2-40B4-BE49-F238E27FC236}">
                  <a16:creationId xmlns:a16="http://schemas.microsoft.com/office/drawing/2014/main" xmlns="" id="{866DD7DC-8C89-40A7-B813-5803F3F5C480}"/>
                </a:ext>
              </a:extLst>
            </p:cNvPr>
            <p:cNvSpPr>
              <a:spLocks/>
            </p:cNvSpPr>
            <p:nvPr/>
          </p:nvSpPr>
          <p:spPr bwMode="auto">
            <a:xfrm>
              <a:off x="5404557" y="824936"/>
              <a:ext cx="2422689" cy="1120297"/>
            </a:xfrm>
            <a:custGeom>
              <a:avLst/>
              <a:gdLst>
                <a:gd name="T0" fmla="*/ 0 w 575"/>
                <a:gd name="T1" fmla="*/ 0 h 266"/>
                <a:gd name="T2" fmla="*/ 112 w 575"/>
                <a:gd name="T3" fmla="*/ 0 h 266"/>
                <a:gd name="T4" fmla="*/ 112 w 575"/>
                <a:gd name="T5" fmla="*/ 28 h 266"/>
                <a:gd name="T6" fmla="*/ 226 w 575"/>
                <a:gd name="T7" fmla="*/ 28 h 266"/>
                <a:gd name="T8" fmla="*/ 226 w 575"/>
                <a:gd name="T9" fmla="*/ 65 h 266"/>
                <a:gd name="T10" fmla="*/ 341 w 575"/>
                <a:gd name="T11" fmla="*/ 65 h 266"/>
                <a:gd name="T12" fmla="*/ 341 w 575"/>
                <a:gd name="T13" fmla="*/ 107 h 266"/>
                <a:gd name="T14" fmla="*/ 376 w 575"/>
                <a:gd name="T15" fmla="*/ 107 h 266"/>
                <a:gd name="T16" fmla="*/ 376 w 575"/>
                <a:gd name="T17" fmla="*/ 149 h 266"/>
                <a:gd name="T18" fmla="*/ 480 w 575"/>
                <a:gd name="T19" fmla="*/ 149 h 266"/>
                <a:gd name="T20" fmla="*/ 480 w 575"/>
                <a:gd name="T21" fmla="*/ 208 h 266"/>
                <a:gd name="T22" fmla="*/ 504 w 575"/>
                <a:gd name="T23" fmla="*/ 208 h 266"/>
                <a:gd name="T24" fmla="*/ 504 w 575"/>
                <a:gd name="T25" fmla="*/ 266 h 266"/>
                <a:gd name="T26" fmla="*/ 575 w 575"/>
                <a:gd name="T27" fmla="*/ 266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575" h="266">
                  <a:moveTo>
                    <a:pt x="0" y="0"/>
                  </a:moveTo>
                  <a:lnTo>
                    <a:pt x="112" y="0"/>
                  </a:lnTo>
                  <a:lnTo>
                    <a:pt x="112" y="28"/>
                  </a:lnTo>
                  <a:lnTo>
                    <a:pt x="226" y="28"/>
                  </a:lnTo>
                  <a:lnTo>
                    <a:pt x="226" y="65"/>
                  </a:lnTo>
                  <a:lnTo>
                    <a:pt x="341" y="65"/>
                  </a:lnTo>
                  <a:lnTo>
                    <a:pt x="341" y="107"/>
                  </a:lnTo>
                  <a:lnTo>
                    <a:pt x="376" y="107"/>
                  </a:lnTo>
                  <a:lnTo>
                    <a:pt x="376" y="149"/>
                  </a:lnTo>
                  <a:lnTo>
                    <a:pt x="480" y="149"/>
                  </a:lnTo>
                  <a:lnTo>
                    <a:pt x="480" y="208"/>
                  </a:lnTo>
                  <a:lnTo>
                    <a:pt x="504" y="208"/>
                  </a:lnTo>
                  <a:lnTo>
                    <a:pt x="504" y="266"/>
                  </a:lnTo>
                  <a:lnTo>
                    <a:pt x="575" y="266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6" name="Line 48">
              <a:extLst>
                <a:ext uri="{FF2B5EF4-FFF2-40B4-BE49-F238E27FC236}">
                  <a16:creationId xmlns:a16="http://schemas.microsoft.com/office/drawing/2014/main" xmlns="" id="{268D8753-564B-40A4-AE03-E6081C2AD5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74557" y="942706"/>
              <a:ext cx="4255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7" name="Line 49">
              <a:extLst>
                <a:ext uri="{FF2B5EF4-FFF2-40B4-BE49-F238E27FC236}">
                  <a16:creationId xmlns:a16="http://schemas.microsoft.com/office/drawing/2014/main" xmlns="" id="{3E3A0D10-E392-438A-A0D2-99B6715031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95340" y="916974"/>
              <a:ext cx="0" cy="4651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8" name="Line 50">
              <a:extLst>
                <a:ext uri="{FF2B5EF4-FFF2-40B4-BE49-F238E27FC236}">
                  <a16:creationId xmlns:a16="http://schemas.microsoft.com/office/drawing/2014/main" xmlns="" id="{3A420CEA-EF86-42E0-A204-A4187057F2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17112" y="942706"/>
              <a:ext cx="4156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79" name="Line 51">
              <a:extLst>
                <a:ext uri="{FF2B5EF4-FFF2-40B4-BE49-F238E27FC236}">
                  <a16:creationId xmlns:a16="http://schemas.microsoft.com/office/drawing/2014/main" xmlns="" id="{24BDE294-D875-489D-853C-8D7C6B764D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37895" y="916974"/>
              <a:ext cx="0" cy="4651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0" name="Line 52">
              <a:extLst>
                <a:ext uri="{FF2B5EF4-FFF2-40B4-BE49-F238E27FC236}">
                  <a16:creationId xmlns:a16="http://schemas.microsoft.com/office/drawing/2014/main" xmlns="" id="{4F32655C-A277-48D9-9591-7ECC026754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58678" y="942706"/>
              <a:ext cx="4651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1" name="Line 53">
              <a:extLst>
                <a:ext uri="{FF2B5EF4-FFF2-40B4-BE49-F238E27FC236}">
                  <a16:creationId xmlns:a16="http://schemas.microsoft.com/office/drawing/2014/main" xmlns="" id="{1A2B352F-1255-40F0-937C-11CD9480D7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79461" y="916974"/>
              <a:ext cx="0" cy="4651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2" name="Line 54">
              <a:extLst>
                <a:ext uri="{FF2B5EF4-FFF2-40B4-BE49-F238E27FC236}">
                  <a16:creationId xmlns:a16="http://schemas.microsoft.com/office/drawing/2014/main" xmlns="" id="{F53E48AF-4A92-4C78-AA88-FDF877497C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19003" y="942706"/>
              <a:ext cx="4651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3" name="Line 55">
              <a:extLst>
                <a:ext uri="{FF2B5EF4-FFF2-40B4-BE49-F238E27FC236}">
                  <a16:creationId xmlns:a16="http://schemas.microsoft.com/office/drawing/2014/main" xmlns="" id="{B9A52A02-F96A-402A-AA5A-3F7E97ED92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44734" y="916974"/>
              <a:ext cx="0" cy="4651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4" name="Line 56">
              <a:extLst>
                <a:ext uri="{FF2B5EF4-FFF2-40B4-BE49-F238E27FC236}">
                  <a16:creationId xmlns:a16="http://schemas.microsoft.com/office/drawing/2014/main" xmlns="" id="{2A2879AB-2C1B-4B98-9622-CD08AE7062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61559" y="1098083"/>
              <a:ext cx="4156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5" name="Line 57">
              <a:extLst>
                <a:ext uri="{FF2B5EF4-FFF2-40B4-BE49-F238E27FC236}">
                  <a16:creationId xmlns:a16="http://schemas.microsoft.com/office/drawing/2014/main" xmlns="" id="{334ED3D2-2F4F-42A2-AF32-5182607CE4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82341" y="1077300"/>
              <a:ext cx="0" cy="4255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6" name="Line 58">
              <a:extLst>
                <a:ext uri="{FF2B5EF4-FFF2-40B4-BE49-F238E27FC236}">
                  <a16:creationId xmlns:a16="http://schemas.microsoft.com/office/drawing/2014/main" xmlns="" id="{07BCAD23-C3EB-4F38-9B97-1F962F11BE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66153" y="1452381"/>
              <a:ext cx="4651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7" name="Line 59">
              <a:extLst>
                <a:ext uri="{FF2B5EF4-FFF2-40B4-BE49-F238E27FC236}">
                  <a16:creationId xmlns:a16="http://schemas.microsoft.com/office/drawing/2014/main" xmlns="" id="{0374A65D-BD6C-4A4C-9515-A71A13AFD7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86936" y="1431598"/>
              <a:ext cx="0" cy="4156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8" name="Line 60">
              <a:extLst>
                <a:ext uri="{FF2B5EF4-FFF2-40B4-BE49-F238E27FC236}">
                  <a16:creationId xmlns:a16="http://schemas.microsoft.com/office/drawing/2014/main" xmlns="" id="{2C7B6BCE-DC39-4378-8605-44A9C8D3A6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83922" y="1452381"/>
              <a:ext cx="4255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89" name="Line 61">
              <a:extLst>
                <a:ext uri="{FF2B5EF4-FFF2-40B4-BE49-F238E27FC236}">
                  <a16:creationId xmlns:a16="http://schemas.microsoft.com/office/drawing/2014/main" xmlns="" id="{C4F3AF75-EC92-4391-AEF0-97B86A1E98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04705" y="1431598"/>
              <a:ext cx="0" cy="4156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90" name="Line 62">
              <a:extLst>
                <a:ext uri="{FF2B5EF4-FFF2-40B4-BE49-F238E27FC236}">
                  <a16:creationId xmlns:a16="http://schemas.microsoft.com/office/drawing/2014/main" xmlns="" id="{AB6BAF1D-4BAB-48C5-A56E-1019FF6918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88694" y="1945233"/>
              <a:ext cx="4156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91" name="Line 63">
              <a:extLst>
                <a:ext uri="{FF2B5EF4-FFF2-40B4-BE49-F238E27FC236}">
                  <a16:creationId xmlns:a16="http://schemas.microsoft.com/office/drawing/2014/main" xmlns="" id="{FE72A85B-549A-4D94-B25B-0414143E7F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09476" y="1924450"/>
              <a:ext cx="0" cy="4255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92" name="Line 64">
              <a:extLst>
                <a:ext uri="{FF2B5EF4-FFF2-40B4-BE49-F238E27FC236}">
                  <a16:creationId xmlns:a16="http://schemas.microsoft.com/office/drawing/2014/main" xmlns="" id="{65E21001-145B-4F0E-9F58-E267F5BFD6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05518" y="1945233"/>
              <a:ext cx="4156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93" name="Line 65">
              <a:extLst>
                <a:ext uri="{FF2B5EF4-FFF2-40B4-BE49-F238E27FC236}">
                  <a16:creationId xmlns:a16="http://schemas.microsoft.com/office/drawing/2014/main" xmlns="" id="{CFFB8279-2CC0-49B7-9368-9C570F0B53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26301" y="1924450"/>
              <a:ext cx="0" cy="4255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94" name="Line 66">
              <a:extLst>
                <a:ext uri="{FF2B5EF4-FFF2-40B4-BE49-F238E27FC236}">
                  <a16:creationId xmlns:a16="http://schemas.microsoft.com/office/drawing/2014/main" xmlns="" id="{E661040C-D096-4993-85A8-57B5C854CC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03893" y="702153"/>
              <a:ext cx="122718" cy="0"/>
            </a:xfrm>
            <a:prstGeom prst="line">
              <a:avLst/>
            </a:pr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95" name="Line 67">
              <a:extLst>
                <a:ext uri="{FF2B5EF4-FFF2-40B4-BE49-F238E27FC236}">
                  <a16:creationId xmlns:a16="http://schemas.microsoft.com/office/drawing/2014/main" xmlns="" id="{F27DC239-CBCD-4AA4-813E-46A79B8805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19628" y="821802"/>
              <a:ext cx="122718" cy="0"/>
            </a:xfrm>
            <a:prstGeom prst="line">
              <a:avLst/>
            </a:prstGeom>
            <a:noFill/>
            <a:ln w="19050" cap="rnd" cmpd="sng">
              <a:solidFill>
                <a:srgbClr val="000000"/>
              </a:solidFill>
              <a:prstDash val="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7" name="図形グループ 6"/>
          <p:cNvGrpSpPr/>
          <p:nvPr/>
        </p:nvGrpSpPr>
        <p:grpSpPr>
          <a:xfrm>
            <a:off x="4990836" y="3236521"/>
            <a:ext cx="2815355" cy="2310893"/>
            <a:chOff x="4988802" y="3857926"/>
            <a:chExt cx="2930278" cy="2306364"/>
          </a:xfrm>
        </p:grpSpPr>
        <p:sp>
          <p:nvSpPr>
            <p:cNvPr id="301" name="Line 74">
              <a:extLst>
                <a:ext uri="{FF2B5EF4-FFF2-40B4-BE49-F238E27FC236}">
                  <a16:creationId xmlns:a16="http://schemas.microsoft.com/office/drawing/2014/main" xmlns="" id="{E8FE16AE-7848-460F-A32F-85578F2F0F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6179" y="5815978"/>
              <a:ext cx="21680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02" name="Line 75">
              <a:extLst>
                <a:ext uri="{FF2B5EF4-FFF2-40B4-BE49-F238E27FC236}">
                  <a16:creationId xmlns:a16="http://schemas.microsoft.com/office/drawing/2014/main" xmlns="" id="{36BF1FE0-69DB-4E75-BA93-259C371BC5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6179" y="5815978"/>
              <a:ext cx="0" cy="375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03" name="Line 76">
              <a:extLst>
                <a:ext uri="{FF2B5EF4-FFF2-40B4-BE49-F238E27FC236}">
                  <a16:creationId xmlns:a16="http://schemas.microsoft.com/office/drawing/2014/main" xmlns="" id="{9FDC3453-4504-4FFC-B77E-BAC9102321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38810" y="5815978"/>
              <a:ext cx="0" cy="375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04" name="Line 77">
              <a:extLst>
                <a:ext uri="{FF2B5EF4-FFF2-40B4-BE49-F238E27FC236}">
                  <a16:creationId xmlns:a16="http://schemas.microsoft.com/office/drawing/2014/main" xmlns="" id="{8FE6F300-EE1E-4F0E-88B4-3B5B0BC9D7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46349" y="5815978"/>
              <a:ext cx="0" cy="375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05" name="Line 78">
              <a:extLst>
                <a:ext uri="{FF2B5EF4-FFF2-40B4-BE49-F238E27FC236}">
                  <a16:creationId xmlns:a16="http://schemas.microsoft.com/office/drawing/2014/main" xmlns="" id="{49B78D2B-6030-4AC0-B15F-4CDD7FB380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3888" y="5815978"/>
              <a:ext cx="0" cy="375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06" name="Line 79">
              <a:extLst>
                <a:ext uri="{FF2B5EF4-FFF2-40B4-BE49-F238E27FC236}">
                  <a16:creationId xmlns:a16="http://schemas.microsoft.com/office/drawing/2014/main" xmlns="" id="{491D462C-5452-4DBB-87A2-4A4DF304D4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66519" y="5815978"/>
              <a:ext cx="0" cy="375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07" name="Line 80">
              <a:extLst>
                <a:ext uri="{FF2B5EF4-FFF2-40B4-BE49-F238E27FC236}">
                  <a16:creationId xmlns:a16="http://schemas.microsoft.com/office/drawing/2014/main" xmlns="" id="{47FB3054-7D65-41F5-BA88-4BDC3EA809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74059" y="5815978"/>
              <a:ext cx="0" cy="375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08" name="Line 81">
              <a:extLst>
                <a:ext uri="{FF2B5EF4-FFF2-40B4-BE49-F238E27FC236}">
                  <a16:creationId xmlns:a16="http://schemas.microsoft.com/office/drawing/2014/main" xmlns="" id="{27FA5C6C-8E5A-4B35-AB8B-F19F945132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81598" y="5815978"/>
              <a:ext cx="0" cy="375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09" name="Line 82">
              <a:extLst>
                <a:ext uri="{FF2B5EF4-FFF2-40B4-BE49-F238E27FC236}">
                  <a16:creationId xmlns:a16="http://schemas.microsoft.com/office/drawing/2014/main" xmlns="" id="{1F5D423E-CD2B-47C3-822B-9844670020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94229" y="5815978"/>
              <a:ext cx="0" cy="375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10" name="Rectangle 83">
              <a:extLst>
                <a:ext uri="{FF2B5EF4-FFF2-40B4-BE49-F238E27FC236}">
                  <a16:creationId xmlns:a16="http://schemas.microsoft.com/office/drawing/2014/main" xmlns="" id="{44C8FCB5-8487-41A6-A96A-546066B056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1555" y="5901613"/>
              <a:ext cx="64156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11" name="Rectangle 84">
              <a:extLst>
                <a:ext uri="{FF2B5EF4-FFF2-40B4-BE49-F238E27FC236}">
                  <a16:creationId xmlns:a16="http://schemas.microsoft.com/office/drawing/2014/main" xmlns="" id="{B515CCB5-D480-46AD-8DEF-B791904820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4186" y="5901613"/>
              <a:ext cx="64156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12" name="Rectangle 85">
              <a:extLst>
                <a:ext uri="{FF2B5EF4-FFF2-40B4-BE49-F238E27FC236}">
                  <a16:creationId xmlns:a16="http://schemas.microsoft.com/office/drawing/2014/main" xmlns="" id="{246BB672-0B47-4944-80F0-1E4D333477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1726" y="5901613"/>
              <a:ext cx="64156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13" name="Rectangle 86">
              <a:extLst>
                <a:ext uri="{FF2B5EF4-FFF2-40B4-BE49-F238E27FC236}">
                  <a16:creationId xmlns:a16="http://schemas.microsoft.com/office/drawing/2014/main" xmlns="" id="{52302D0D-4BB7-4423-A39E-60C5BF221C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19265" y="5901613"/>
              <a:ext cx="64156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14" name="Rectangle 87">
              <a:extLst>
                <a:ext uri="{FF2B5EF4-FFF2-40B4-BE49-F238E27FC236}">
                  <a16:creationId xmlns:a16="http://schemas.microsoft.com/office/drawing/2014/main" xmlns="" id="{B7B0C24A-494E-4744-9E81-32FEEEA70A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31896" y="5901613"/>
              <a:ext cx="64156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15" name="Rectangle 88">
              <a:extLst>
                <a:ext uri="{FF2B5EF4-FFF2-40B4-BE49-F238E27FC236}">
                  <a16:creationId xmlns:a16="http://schemas.microsoft.com/office/drawing/2014/main" xmlns="" id="{11809AB4-B087-4FCF-9356-97712627F9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8050" y="5901613"/>
              <a:ext cx="128311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16" name="Rectangle 89">
              <a:extLst>
                <a:ext uri="{FF2B5EF4-FFF2-40B4-BE49-F238E27FC236}">
                  <a16:creationId xmlns:a16="http://schemas.microsoft.com/office/drawing/2014/main" xmlns="" id="{58BB9D1A-87E6-4B71-B143-1613CA7A9D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25589" y="5901613"/>
              <a:ext cx="128311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17" name="Rectangle 90">
              <a:extLst>
                <a:ext uri="{FF2B5EF4-FFF2-40B4-BE49-F238E27FC236}">
                  <a16:creationId xmlns:a16="http://schemas.microsoft.com/office/drawing/2014/main" xmlns="" id="{DC7D48F5-B3AC-483C-8AEF-0B5667D9FD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38220" y="5901613"/>
              <a:ext cx="128311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18" name="Line 91">
              <a:extLst>
                <a:ext uri="{FF2B5EF4-FFF2-40B4-BE49-F238E27FC236}">
                  <a16:creationId xmlns:a16="http://schemas.microsoft.com/office/drawing/2014/main" xmlns="" id="{9B1108AF-498B-4513-B0D2-F6336860FF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26179" y="3932014"/>
              <a:ext cx="0" cy="181083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19" name="Line 92">
              <a:extLst>
                <a:ext uri="{FF2B5EF4-FFF2-40B4-BE49-F238E27FC236}">
                  <a16:creationId xmlns:a16="http://schemas.microsoft.com/office/drawing/2014/main" xmlns="" id="{811A2880-ACEF-4EBF-BDA9-84FE346789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87482" y="5742852"/>
              <a:ext cx="3869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20" name="Line 93">
              <a:extLst>
                <a:ext uri="{FF2B5EF4-FFF2-40B4-BE49-F238E27FC236}">
                  <a16:creationId xmlns:a16="http://schemas.microsoft.com/office/drawing/2014/main" xmlns="" id="{76C36EC9-3974-4DBF-BD55-A6051225D4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87482" y="5378183"/>
              <a:ext cx="3869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21" name="Line 94">
              <a:extLst>
                <a:ext uri="{FF2B5EF4-FFF2-40B4-BE49-F238E27FC236}">
                  <a16:creationId xmlns:a16="http://schemas.microsoft.com/office/drawing/2014/main" xmlns="" id="{F8A851EE-B835-4059-91B1-D076219752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87482" y="5017362"/>
              <a:ext cx="3869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22" name="Line 95">
              <a:extLst>
                <a:ext uri="{FF2B5EF4-FFF2-40B4-BE49-F238E27FC236}">
                  <a16:creationId xmlns:a16="http://schemas.microsoft.com/office/drawing/2014/main" xmlns="" id="{D5DD3C64-749B-4CF0-8E06-3BE59F0590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87482" y="4656542"/>
              <a:ext cx="3869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23" name="Line 96">
              <a:extLst>
                <a:ext uri="{FF2B5EF4-FFF2-40B4-BE49-F238E27FC236}">
                  <a16:creationId xmlns:a16="http://schemas.microsoft.com/office/drawing/2014/main" xmlns="" id="{E8FF0F02-8A0E-4F52-8B47-6B8E976AFB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87482" y="4291873"/>
              <a:ext cx="3869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24" name="Line 97">
              <a:extLst>
                <a:ext uri="{FF2B5EF4-FFF2-40B4-BE49-F238E27FC236}">
                  <a16:creationId xmlns:a16="http://schemas.microsoft.com/office/drawing/2014/main" xmlns="" id="{40446DF7-050E-4EC3-845C-4631A1720E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387482" y="3932014"/>
              <a:ext cx="3869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25" name="Rectangle 98">
              <a:extLst>
                <a:ext uri="{FF2B5EF4-FFF2-40B4-BE49-F238E27FC236}">
                  <a16:creationId xmlns:a16="http://schemas.microsoft.com/office/drawing/2014/main" xmlns="" id="{BFBBD7E7-945E-40C2-B0D0-7D851DDD4A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4813" y="5674536"/>
              <a:ext cx="64156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26" name="Rectangle 99">
              <a:extLst>
                <a:ext uri="{FF2B5EF4-FFF2-40B4-BE49-F238E27FC236}">
                  <a16:creationId xmlns:a16="http://schemas.microsoft.com/office/drawing/2014/main" xmlns="" id="{E9828449-B841-46CB-874C-3B7CB04955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4263" y="5314678"/>
              <a:ext cx="128311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27" name="Rectangle 100">
              <a:extLst>
                <a:ext uri="{FF2B5EF4-FFF2-40B4-BE49-F238E27FC236}">
                  <a16:creationId xmlns:a16="http://schemas.microsoft.com/office/drawing/2014/main" xmlns="" id="{BF607BE8-DF68-49D1-913B-C170D234C1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4263" y="4953858"/>
              <a:ext cx="128311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28" name="Rectangle 101">
              <a:extLst>
                <a:ext uri="{FF2B5EF4-FFF2-40B4-BE49-F238E27FC236}">
                  <a16:creationId xmlns:a16="http://schemas.microsoft.com/office/drawing/2014/main" xmlns="" id="{3B8427FC-7A9E-4372-9CD5-DA7182CE1D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4263" y="4589189"/>
              <a:ext cx="128311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29" name="Rectangle 102">
              <a:extLst>
                <a:ext uri="{FF2B5EF4-FFF2-40B4-BE49-F238E27FC236}">
                  <a16:creationId xmlns:a16="http://schemas.microsoft.com/office/drawing/2014/main" xmlns="" id="{6BB71920-AD7A-495B-B05E-F1F548DCEF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4263" y="4228368"/>
              <a:ext cx="128311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30" name="Rectangle 103">
              <a:extLst>
                <a:ext uri="{FF2B5EF4-FFF2-40B4-BE49-F238E27FC236}">
                  <a16:creationId xmlns:a16="http://schemas.microsoft.com/office/drawing/2014/main" xmlns="" id="{ED584F64-DC75-4F31-9F55-A2ABDB34F2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2979" y="3874283"/>
              <a:ext cx="192467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331" name="Freeform 104">
              <a:extLst>
                <a:ext uri="{FF2B5EF4-FFF2-40B4-BE49-F238E27FC236}">
                  <a16:creationId xmlns:a16="http://schemas.microsoft.com/office/drawing/2014/main" xmlns="" id="{003B6ED7-CD7D-4670-9429-6EF1C825D225}"/>
                </a:ext>
              </a:extLst>
            </p:cNvPr>
            <p:cNvSpPr>
              <a:spLocks/>
            </p:cNvSpPr>
            <p:nvPr/>
          </p:nvSpPr>
          <p:spPr bwMode="auto">
            <a:xfrm>
              <a:off x="5426179" y="3857926"/>
              <a:ext cx="2319783" cy="1958052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32" name="Rectangle 105">
              <a:extLst>
                <a:ext uri="{FF2B5EF4-FFF2-40B4-BE49-F238E27FC236}">
                  <a16:creationId xmlns:a16="http://schemas.microsoft.com/office/drawing/2014/main" xmlns="" id="{5E102E7A-E733-417B-8D41-DE5F9C47C0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1586" y="6033432"/>
              <a:ext cx="793288" cy="130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solidFill>
                    <a:srgbClr val="000000"/>
                  </a:solidFill>
                  <a:latin typeface="Arial"/>
                  <a:cs typeface="Arial"/>
                </a:rPr>
                <a:t>(months)</a:t>
              </a:r>
              <a:endParaRPr kumimoji="0" lang="ja-JP" altLang="ja-JP" sz="900" b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33" name="Rectangle 106">
              <a:extLst>
                <a:ext uri="{FF2B5EF4-FFF2-40B4-BE49-F238E27FC236}">
                  <a16:creationId xmlns:a16="http://schemas.microsoft.com/office/drawing/2014/main" xmlns="" id="{8EDC0E16-FFD9-48D0-9B49-CB7D0C4223E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504731" y="4761029"/>
              <a:ext cx="1121911" cy="1537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1000" b="1" dirty="0">
                  <a:solidFill>
                    <a:srgbClr val="000000"/>
                  </a:solidFill>
                  <a:latin typeface="Arial"/>
                  <a:cs typeface="Arial"/>
                </a:rPr>
                <a:t>Overall survival (%)</a:t>
              </a:r>
              <a:endParaRPr kumimoji="0" lang="ja-JP" altLang="ja-JP" sz="1000" b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34" name="Freeform 107">
              <a:extLst>
                <a:ext uri="{FF2B5EF4-FFF2-40B4-BE49-F238E27FC236}">
                  <a16:creationId xmlns:a16="http://schemas.microsoft.com/office/drawing/2014/main" xmlns="" id="{A0866E77-4E3B-4AAE-8D99-096115CAED1B}"/>
                </a:ext>
              </a:extLst>
            </p:cNvPr>
            <p:cNvSpPr>
              <a:spLocks/>
            </p:cNvSpPr>
            <p:nvPr/>
          </p:nvSpPr>
          <p:spPr bwMode="auto">
            <a:xfrm>
              <a:off x="5426179" y="3932014"/>
              <a:ext cx="1157855" cy="1810837"/>
            </a:xfrm>
            <a:custGeom>
              <a:avLst/>
              <a:gdLst>
                <a:gd name="T0" fmla="*/ 0 w 267"/>
                <a:gd name="T1" fmla="*/ 0 h 442"/>
                <a:gd name="T2" fmla="*/ 77 w 267"/>
                <a:gd name="T3" fmla="*/ 0 h 442"/>
                <a:gd name="T4" fmla="*/ 77 w 267"/>
                <a:gd name="T5" fmla="*/ 110 h 442"/>
                <a:gd name="T6" fmla="*/ 215 w 267"/>
                <a:gd name="T7" fmla="*/ 110 h 442"/>
                <a:gd name="T8" fmla="*/ 215 w 267"/>
                <a:gd name="T9" fmla="*/ 221 h 442"/>
                <a:gd name="T10" fmla="*/ 267 w 267"/>
                <a:gd name="T11" fmla="*/ 221 h 442"/>
                <a:gd name="T12" fmla="*/ 267 w 267"/>
                <a:gd name="T13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67" h="442">
                  <a:moveTo>
                    <a:pt x="0" y="0"/>
                  </a:moveTo>
                  <a:lnTo>
                    <a:pt x="77" y="0"/>
                  </a:lnTo>
                  <a:lnTo>
                    <a:pt x="77" y="110"/>
                  </a:lnTo>
                  <a:lnTo>
                    <a:pt x="215" y="110"/>
                  </a:lnTo>
                  <a:lnTo>
                    <a:pt x="215" y="221"/>
                  </a:lnTo>
                  <a:lnTo>
                    <a:pt x="267" y="221"/>
                  </a:lnTo>
                  <a:lnTo>
                    <a:pt x="267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35" name="Line 108">
              <a:extLst>
                <a:ext uri="{FF2B5EF4-FFF2-40B4-BE49-F238E27FC236}">
                  <a16:creationId xmlns:a16="http://schemas.microsoft.com/office/drawing/2014/main" xmlns="" id="{D0B5D9FB-5E0A-4478-AD60-1711C222D5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63054" y="4837433"/>
              <a:ext cx="427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36" name="Line 109">
              <a:extLst>
                <a:ext uri="{FF2B5EF4-FFF2-40B4-BE49-F238E27FC236}">
                  <a16:creationId xmlns:a16="http://schemas.microsoft.com/office/drawing/2014/main" xmlns="" id="{F7B750E8-8FF1-4DA0-8C18-7954175B41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84439" y="4816265"/>
              <a:ext cx="0" cy="4137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37" name="Freeform 110">
              <a:extLst>
                <a:ext uri="{FF2B5EF4-FFF2-40B4-BE49-F238E27FC236}">
                  <a16:creationId xmlns:a16="http://schemas.microsoft.com/office/drawing/2014/main" xmlns="" id="{F62B8699-E87D-4D4F-B0D9-2608EC65E8D9}"/>
                </a:ext>
              </a:extLst>
            </p:cNvPr>
            <p:cNvSpPr>
              <a:spLocks/>
            </p:cNvSpPr>
            <p:nvPr/>
          </p:nvSpPr>
          <p:spPr bwMode="auto">
            <a:xfrm>
              <a:off x="5426179" y="3932014"/>
              <a:ext cx="2492901" cy="1146928"/>
            </a:xfrm>
            <a:custGeom>
              <a:avLst/>
              <a:gdLst>
                <a:gd name="T0" fmla="*/ 0 w 575"/>
                <a:gd name="T1" fmla="*/ 0 h 280"/>
                <a:gd name="T2" fmla="*/ 112 w 575"/>
                <a:gd name="T3" fmla="*/ 0 h 280"/>
                <a:gd name="T4" fmla="*/ 112 w 575"/>
                <a:gd name="T5" fmla="*/ 20 h 280"/>
                <a:gd name="T6" fmla="*/ 226 w 575"/>
                <a:gd name="T7" fmla="*/ 20 h 280"/>
                <a:gd name="T8" fmla="*/ 226 w 575"/>
                <a:gd name="T9" fmla="*/ 48 h 280"/>
                <a:gd name="T10" fmla="*/ 289 w 575"/>
                <a:gd name="T11" fmla="*/ 48 h 280"/>
                <a:gd name="T12" fmla="*/ 289 w 575"/>
                <a:gd name="T13" fmla="*/ 78 h 280"/>
                <a:gd name="T14" fmla="*/ 341 w 575"/>
                <a:gd name="T15" fmla="*/ 78 h 280"/>
                <a:gd name="T16" fmla="*/ 341 w 575"/>
                <a:gd name="T17" fmla="*/ 109 h 280"/>
                <a:gd name="T18" fmla="*/ 346 w 575"/>
                <a:gd name="T19" fmla="*/ 109 h 280"/>
                <a:gd name="T20" fmla="*/ 346 w 575"/>
                <a:gd name="T21" fmla="*/ 139 h 280"/>
                <a:gd name="T22" fmla="*/ 353 w 575"/>
                <a:gd name="T23" fmla="*/ 139 h 280"/>
                <a:gd name="T24" fmla="*/ 353 w 575"/>
                <a:gd name="T25" fmla="*/ 169 h 280"/>
                <a:gd name="T26" fmla="*/ 376 w 575"/>
                <a:gd name="T27" fmla="*/ 169 h 280"/>
                <a:gd name="T28" fmla="*/ 376 w 575"/>
                <a:gd name="T29" fmla="*/ 200 h 280"/>
                <a:gd name="T30" fmla="*/ 480 w 575"/>
                <a:gd name="T31" fmla="*/ 200 h 280"/>
                <a:gd name="T32" fmla="*/ 480 w 575"/>
                <a:gd name="T33" fmla="*/ 240 h 280"/>
                <a:gd name="T34" fmla="*/ 504 w 575"/>
                <a:gd name="T35" fmla="*/ 240 h 280"/>
                <a:gd name="T36" fmla="*/ 504 w 575"/>
                <a:gd name="T37" fmla="*/ 280 h 280"/>
                <a:gd name="T38" fmla="*/ 575 w 575"/>
                <a:gd name="T3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575" h="280">
                  <a:moveTo>
                    <a:pt x="0" y="0"/>
                  </a:moveTo>
                  <a:lnTo>
                    <a:pt x="112" y="0"/>
                  </a:lnTo>
                  <a:lnTo>
                    <a:pt x="112" y="20"/>
                  </a:lnTo>
                  <a:lnTo>
                    <a:pt x="226" y="20"/>
                  </a:lnTo>
                  <a:lnTo>
                    <a:pt x="226" y="48"/>
                  </a:lnTo>
                  <a:lnTo>
                    <a:pt x="289" y="48"/>
                  </a:lnTo>
                  <a:lnTo>
                    <a:pt x="289" y="78"/>
                  </a:lnTo>
                  <a:lnTo>
                    <a:pt x="341" y="78"/>
                  </a:lnTo>
                  <a:lnTo>
                    <a:pt x="341" y="109"/>
                  </a:lnTo>
                  <a:lnTo>
                    <a:pt x="346" y="109"/>
                  </a:lnTo>
                  <a:lnTo>
                    <a:pt x="346" y="139"/>
                  </a:lnTo>
                  <a:lnTo>
                    <a:pt x="353" y="139"/>
                  </a:lnTo>
                  <a:lnTo>
                    <a:pt x="353" y="169"/>
                  </a:lnTo>
                  <a:lnTo>
                    <a:pt x="376" y="169"/>
                  </a:lnTo>
                  <a:lnTo>
                    <a:pt x="376" y="200"/>
                  </a:lnTo>
                  <a:lnTo>
                    <a:pt x="480" y="200"/>
                  </a:lnTo>
                  <a:lnTo>
                    <a:pt x="480" y="240"/>
                  </a:lnTo>
                  <a:lnTo>
                    <a:pt x="504" y="240"/>
                  </a:lnTo>
                  <a:lnTo>
                    <a:pt x="504" y="280"/>
                  </a:lnTo>
                  <a:lnTo>
                    <a:pt x="575" y="280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38" name="Line 111">
              <a:extLst>
                <a:ext uri="{FF2B5EF4-FFF2-40B4-BE49-F238E27FC236}">
                  <a16:creationId xmlns:a16="http://schemas.microsoft.com/office/drawing/2014/main" xmlns="" id="{C55FDD4D-4327-4DE3-B72C-D368E6B720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9120" y="4013800"/>
              <a:ext cx="43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39" name="Line 112">
              <a:extLst>
                <a:ext uri="{FF2B5EF4-FFF2-40B4-BE49-F238E27FC236}">
                  <a16:creationId xmlns:a16="http://schemas.microsoft.com/office/drawing/2014/main" xmlns="" id="{9640815C-8FD1-48F7-9CDD-4AF14E2A0C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11523" y="3993594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0" name="Line 113">
              <a:extLst>
                <a:ext uri="{FF2B5EF4-FFF2-40B4-BE49-F238E27FC236}">
                  <a16:creationId xmlns:a16="http://schemas.microsoft.com/office/drawing/2014/main" xmlns="" id="{7988AC51-77E7-4A91-BA92-A8BA5A9D0B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15596" y="4013800"/>
              <a:ext cx="43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1" name="Line 114">
              <a:extLst>
                <a:ext uri="{FF2B5EF4-FFF2-40B4-BE49-F238E27FC236}">
                  <a16:creationId xmlns:a16="http://schemas.microsoft.com/office/drawing/2014/main" xmlns="" id="{1B5190B1-92C5-4E19-927D-2CF7F6F698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36982" y="3993594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2" name="Line 115">
              <a:extLst>
                <a:ext uri="{FF2B5EF4-FFF2-40B4-BE49-F238E27FC236}">
                  <a16:creationId xmlns:a16="http://schemas.microsoft.com/office/drawing/2014/main" xmlns="" id="{A9A20F3B-52B0-402A-B2B2-70376005C6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28835" y="4013800"/>
              <a:ext cx="427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3" name="Line 116">
              <a:extLst>
                <a:ext uri="{FF2B5EF4-FFF2-40B4-BE49-F238E27FC236}">
                  <a16:creationId xmlns:a16="http://schemas.microsoft.com/office/drawing/2014/main" xmlns="" id="{B81BFEE2-8DA8-4472-9402-A7B65036D4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50220" y="3993594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4" name="Line 117">
              <a:extLst>
                <a:ext uri="{FF2B5EF4-FFF2-40B4-BE49-F238E27FC236}">
                  <a16:creationId xmlns:a16="http://schemas.microsoft.com/office/drawing/2014/main" xmlns="" id="{61F280B3-B330-4E01-9D37-C3E15FA97D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59385" y="4013800"/>
              <a:ext cx="427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5" name="Line 118">
              <a:extLst>
                <a:ext uri="{FF2B5EF4-FFF2-40B4-BE49-F238E27FC236}">
                  <a16:creationId xmlns:a16="http://schemas.microsoft.com/office/drawing/2014/main" xmlns="" id="{1948B117-80DD-488D-8034-AA8AC7EE5C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80770" y="3993594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6" name="Line 119">
              <a:extLst>
                <a:ext uri="{FF2B5EF4-FFF2-40B4-BE49-F238E27FC236}">
                  <a16:creationId xmlns:a16="http://schemas.microsoft.com/office/drawing/2014/main" xmlns="" id="{F932B840-7D7B-4CD4-BE45-5688360685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02156" y="4013800"/>
              <a:ext cx="4786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7" name="Line 120">
              <a:extLst>
                <a:ext uri="{FF2B5EF4-FFF2-40B4-BE49-F238E27FC236}">
                  <a16:creationId xmlns:a16="http://schemas.microsoft.com/office/drawing/2014/main" xmlns="" id="{8CAEFC9D-BBCE-4C65-9CAF-E5C19EA4E9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23541" y="3993594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8" name="Line 121">
              <a:extLst>
                <a:ext uri="{FF2B5EF4-FFF2-40B4-BE49-F238E27FC236}">
                  <a16:creationId xmlns:a16="http://schemas.microsoft.com/office/drawing/2014/main" xmlns="" id="{BA2D0056-082F-483A-BFD0-20726EF0ED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67127" y="4013800"/>
              <a:ext cx="4786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49" name="Line 122">
              <a:extLst>
                <a:ext uri="{FF2B5EF4-FFF2-40B4-BE49-F238E27FC236}">
                  <a16:creationId xmlns:a16="http://schemas.microsoft.com/office/drawing/2014/main" xmlns="" id="{D92948A4-E19C-4217-8415-8D0373FEB2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93604" y="3993594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50" name="Line 123">
              <a:extLst>
                <a:ext uri="{FF2B5EF4-FFF2-40B4-BE49-F238E27FC236}">
                  <a16:creationId xmlns:a16="http://schemas.microsoft.com/office/drawing/2014/main" xmlns="" id="{21314CD1-5809-400B-9794-6095A6A1C9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10916" y="4128301"/>
              <a:ext cx="427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51" name="Line 124">
              <a:extLst>
                <a:ext uri="{FF2B5EF4-FFF2-40B4-BE49-F238E27FC236}">
                  <a16:creationId xmlns:a16="http://schemas.microsoft.com/office/drawing/2014/main" xmlns="" id="{82B7D646-41FB-41A1-A408-0EEB4741FC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32301" y="4108095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61" name="Line 125">
              <a:extLst>
                <a:ext uri="{FF2B5EF4-FFF2-40B4-BE49-F238E27FC236}">
                  <a16:creationId xmlns:a16="http://schemas.microsoft.com/office/drawing/2014/main" xmlns="" id="{8B4B676B-0B11-4A9D-8399-A0DE30F824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38828" y="4750836"/>
              <a:ext cx="4786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64" name="Line 126">
              <a:extLst>
                <a:ext uri="{FF2B5EF4-FFF2-40B4-BE49-F238E27FC236}">
                  <a16:creationId xmlns:a16="http://schemas.microsoft.com/office/drawing/2014/main" xmlns="" id="{E717AB3B-E336-49D7-B6C0-4A37800272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60213" y="4726782"/>
              <a:ext cx="0" cy="4522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97" name="Line 127">
              <a:extLst>
                <a:ext uri="{FF2B5EF4-FFF2-40B4-BE49-F238E27FC236}">
                  <a16:creationId xmlns:a16="http://schemas.microsoft.com/office/drawing/2014/main" xmlns="" id="{172537BE-1A12-4210-ADAA-5973A2523A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60010" y="4750836"/>
              <a:ext cx="43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400" name="Line 128">
              <a:extLst>
                <a:ext uri="{FF2B5EF4-FFF2-40B4-BE49-F238E27FC236}">
                  <a16:creationId xmlns:a16="http://schemas.microsoft.com/office/drawing/2014/main" xmlns="" id="{8D4539CE-A489-41E5-9349-D19205B3C9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81395" y="4726782"/>
              <a:ext cx="0" cy="4522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460" name="Line 129">
              <a:extLst>
                <a:ext uri="{FF2B5EF4-FFF2-40B4-BE49-F238E27FC236}">
                  <a16:creationId xmlns:a16="http://schemas.microsoft.com/office/drawing/2014/main" xmlns="" id="{6DC7E171-EF72-480D-8EFD-085221F96D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76512" y="5078942"/>
              <a:ext cx="427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463" name="Line 130">
              <a:extLst>
                <a:ext uri="{FF2B5EF4-FFF2-40B4-BE49-F238E27FC236}">
                  <a16:creationId xmlns:a16="http://schemas.microsoft.com/office/drawing/2014/main" xmlns="" id="{D5A658CD-558E-401F-B66A-7ABD6FA044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97897" y="5058736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464" name="Line 131">
              <a:extLst>
                <a:ext uri="{FF2B5EF4-FFF2-40B4-BE49-F238E27FC236}">
                  <a16:creationId xmlns:a16="http://schemas.microsoft.com/office/drawing/2014/main" xmlns="" id="{7B9215A8-4062-4A6F-8FCC-406F31A760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93824" y="5078942"/>
              <a:ext cx="4277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465" name="Line 132">
              <a:extLst>
                <a:ext uri="{FF2B5EF4-FFF2-40B4-BE49-F238E27FC236}">
                  <a16:creationId xmlns:a16="http://schemas.microsoft.com/office/drawing/2014/main" xmlns="" id="{957D4E3D-A7A6-4FF8-B406-F13D449873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15209" y="5058736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466" name="Line 133">
              <a:extLst>
                <a:ext uri="{FF2B5EF4-FFF2-40B4-BE49-F238E27FC236}">
                  <a16:creationId xmlns:a16="http://schemas.microsoft.com/office/drawing/2014/main" xmlns="" id="{D727AC0F-CD2B-4F61-803F-A88782F3E8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49833" y="5078942"/>
              <a:ext cx="4378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467" name="Line 134">
              <a:extLst>
                <a:ext uri="{FF2B5EF4-FFF2-40B4-BE49-F238E27FC236}">
                  <a16:creationId xmlns:a16="http://schemas.microsoft.com/office/drawing/2014/main" xmlns="" id="{15A54A75-02D5-45D4-BF39-8CBB8C1209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71218" y="5058736"/>
              <a:ext cx="0" cy="4041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468" name="Line 135">
              <a:extLst>
                <a:ext uri="{FF2B5EF4-FFF2-40B4-BE49-F238E27FC236}">
                  <a16:creationId xmlns:a16="http://schemas.microsoft.com/office/drawing/2014/main" xmlns="" id="{4BDA1AE1-7BD1-4B89-887B-185108145A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03364" y="3977098"/>
              <a:ext cx="125256" cy="0"/>
            </a:xfrm>
            <a:prstGeom prst="line">
              <a:avLst/>
            </a:pr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469" name="Line 136">
              <a:extLst>
                <a:ext uri="{FF2B5EF4-FFF2-40B4-BE49-F238E27FC236}">
                  <a16:creationId xmlns:a16="http://schemas.microsoft.com/office/drawing/2014/main" xmlns="" id="{66B1283D-CD57-471E-94F5-0228A3E528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12529" y="4096410"/>
              <a:ext cx="125256" cy="0"/>
            </a:xfrm>
            <a:prstGeom prst="line">
              <a:avLst/>
            </a:prstGeom>
            <a:noFill/>
            <a:ln w="19050" cap="rnd" cmpd="sng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sp>
        <p:nvSpPr>
          <p:cNvPr id="450" name="テキスト ボックス 449"/>
          <p:cNvSpPr txBox="1"/>
          <p:nvPr/>
        </p:nvSpPr>
        <p:spPr>
          <a:xfrm>
            <a:off x="58062" y="5921287"/>
            <a:ext cx="908593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Supplemental Figure </a:t>
            </a:r>
            <a:r>
              <a:rPr lang="en-US" altLang="ja-JP" sz="1100" b="1" dirty="0" smtClean="0">
                <a:latin typeface="Arial"/>
                <a:cs typeface="Arial"/>
              </a:rPr>
              <a:t>3</a:t>
            </a:r>
            <a:r>
              <a:rPr lang="en-US" altLang="ja-JP" sz="1100" b="1" dirty="0" smtClean="0">
                <a:latin typeface="Arial"/>
                <a:cs typeface="Arial"/>
              </a:rPr>
              <a:t>: </a:t>
            </a:r>
            <a:r>
              <a:rPr lang="en-US" altLang="ja-JP" sz="1100" b="1" dirty="0">
                <a:latin typeface="Arial"/>
                <a:cs typeface="Arial"/>
              </a:rPr>
              <a:t>Kaplan-Meier estimates of progression-free survival (PFS) and overall survival (OS) according to the changes in</a:t>
            </a:r>
            <a:r>
              <a:rPr lang="ja-JP" altLang="ja-JP" sz="1100" dirty="0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 tumor markers (CEA and CA19-9) in </a:t>
            </a:r>
            <a:r>
              <a:rPr lang="en-US" altLang="ja-JP" sz="1100" b="1" dirty="0" err="1">
                <a:latin typeface="Arial"/>
                <a:cs typeface="Arial"/>
              </a:rPr>
              <a:t>mCRC</a:t>
            </a:r>
            <a:r>
              <a:rPr lang="en-US" altLang="ja-JP" sz="1100" b="1" dirty="0">
                <a:latin typeface="Arial"/>
                <a:cs typeface="Arial"/>
              </a:rPr>
              <a:t> patients treated with second-line chemotherapy.  </a:t>
            </a:r>
            <a:r>
              <a:rPr lang="en-US" altLang="ja-JP" sz="1100" dirty="0">
                <a:latin typeface="Arial"/>
                <a:cs typeface="Arial"/>
              </a:rPr>
              <a:t>Comparison of PFS (A) and OS (B) in patients with higher (&gt; average) and lower (≤ average) CEA levels 8 weeks after initiation of second-line chemotherapy.  Comparison of PFS (C) and OS (D) in patients with higher (&gt; average) and lower (≤ average) CA19-9 levels 8 weeks after initiation of second-line chemotherapy.   </a:t>
            </a:r>
            <a:r>
              <a:rPr lang="en-US" altLang="ja-JP" sz="1100" i="1" dirty="0">
                <a:latin typeface="Arial"/>
                <a:cs typeface="Arial"/>
              </a:rPr>
              <a:t>P</a:t>
            </a:r>
            <a:r>
              <a:rPr lang="en-US" altLang="ja-JP" sz="1100" dirty="0">
                <a:latin typeface="Arial"/>
                <a:cs typeface="Arial"/>
              </a:rPr>
              <a:t> values were calculated by the log-rank test.</a:t>
            </a:r>
            <a:endParaRPr lang="ja-JP" altLang="ja-JP" sz="1100" dirty="0">
              <a:latin typeface="Arial"/>
              <a:cs typeface="Arial"/>
            </a:endParaRPr>
          </a:p>
          <a:p>
            <a:endParaRPr kumimoji="1" lang="ja-JP" altLang="en-US" sz="11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9949032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6</TotalTime>
  <Words>525</Words>
  <Application>Microsoft Macintosh PowerPoint</Application>
  <PresentationFormat>画面に合わせる (4:3)</PresentationFormat>
  <Paragraphs>16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がん研有明病院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隅 寛木</dc:creator>
  <cp:lastModifiedBy>大隅 寛木</cp:lastModifiedBy>
  <cp:revision>300</cp:revision>
  <dcterms:created xsi:type="dcterms:W3CDTF">2019-04-24T00:39:12Z</dcterms:created>
  <dcterms:modified xsi:type="dcterms:W3CDTF">2019-10-15T12:17:46Z</dcterms:modified>
</cp:coreProperties>
</file>